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docx" ContentType="application/vnd.openxmlformats-officedocument.wordprocessingml.document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3"/>
  </p:notesMasterIdLst>
  <p:sldIdLst>
    <p:sldId id="257" r:id="rId2"/>
    <p:sldId id="258" r:id="rId3"/>
    <p:sldId id="259" r:id="rId4"/>
    <p:sldId id="260" r:id="rId5"/>
    <p:sldId id="261" r:id="rId6"/>
    <p:sldId id="267" r:id="rId7"/>
    <p:sldId id="262" r:id="rId8"/>
    <p:sldId id="263" r:id="rId9"/>
    <p:sldId id="264" r:id="rId10"/>
    <p:sldId id="265" r:id="rId11"/>
    <p:sldId id="266" r:id="rId1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94" y="-27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0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5153094-DE59-4923-BD4F-8E7753FEB2C7}" type="datetimeFigureOut">
              <a:rPr lang="en-US" smtClean="0"/>
              <a:t>9/14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C73E20-4D47-4200-B6D0-B813D42041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08735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B51836D-2FE7-497E-BBEA-2423F37E3011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09935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712D8-C8F7-489B-A0FE-301E0A70966A}" type="datetimeFigureOut">
              <a:rPr lang="en-US" smtClean="0"/>
              <a:t>9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627CCF-CFED-4340-BCDD-7F4FE3AE9A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50251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712D8-C8F7-489B-A0FE-301E0A70966A}" type="datetimeFigureOut">
              <a:rPr lang="en-US" smtClean="0"/>
              <a:t>9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627CCF-CFED-4340-BCDD-7F4FE3AE9A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39972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712D8-C8F7-489B-A0FE-301E0A70966A}" type="datetimeFigureOut">
              <a:rPr lang="en-US" smtClean="0"/>
              <a:t>9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627CCF-CFED-4340-BCDD-7F4FE3AE9A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90752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712D8-C8F7-489B-A0FE-301E0A70966A}" type="datetimeFigureOut">
              <a:rPr lang="en-US" smtClean="0"/>
              <a:t>9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627CCF-CFED-4340-BCDD-7F4FE3AE9A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21374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712D8-C8F7-489B-A0FE-301E0A70966A}" type="datetimeFigureOut">
              <a:rPr lang="en-US" smtClean="0"/>
              <a:t>9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627CCF-CFED-4340-BCDD-7F4FE3AE9A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84439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712D8-C8F7-489B-A0FE-301E0A70966A}" type="datetimeFigureOut">
              <a:rPr lang="en-US" smtClean="0"/>
              <a:t>9/14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627CCF-CFED-4340-BCDD-7F4FE3AE9A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24250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712D8-C8F7-489B-A0FE-301E0A70966A}" type="datetimeFigureOut">
              <a:rPr lang="en-US" smtClean="0"/>
              <a:t>9/14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627CCF-CFED-4340-BCDD-7F4FE3AE9A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36828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712D8-C8F7-489B-A0FE-301E0A70966A}" type="datetimeFigureOut">
              <a:rPr lang="en-US" smtClean="0"/>
              <a:t>9/14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627CCF-CFED-4340-BCDD-7F4FE3AE9A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74710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712D8-C8F7-489B-A0FE-301E0A70966A}" type="datetimeFigureOut">
              <a:rPr lang="en-US" smtClean="0"/>
              <a:t>9/14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627CCF-CFED-4340-BCDD-7F4FE3AE9A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6055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712D8-C8F7-489B-A0FE-301E0A70966A}" type="datetimeFigureOut">
              <a:rPr lang="en-US" smtClean="0"/>
              <a:t>9/14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627CCF-CFED-4340-BCDD-7F4FE3AE9A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25743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712D8-C8F7-489B-A0FE-301E0A70966A}" type="datetimeFigureOut">
              <a:rPr lang="en-US" smtClean="0"/>
              <a:t>9/14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627CCF-CFED-4340-BCDD-7F4FE3AE9A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08760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9712D8-C8F7-489B-A0FE-301E0A70966A}" type="datetimeFigureOut">
              <a:rPr lang="en-US" smtClean="0"/>
              <a:t>9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627CCF-CFED-4340-BCDD-7F4FE3AE9A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44154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.emf"/><Relationship Id="rId5" Type="http://schemas.openxmlformats.org/officeDocument/2006/relationships/image" Target="../media/image6.emf"/><Relationship Id="rId4" Type="http://schemas.openxmlformats.org/officeDocument/2006/relationships/image" Target="../media/image5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0.emf"/><Relationship Id="rId5" Type="http://schemas.openxmlformats.org/officeDocument/2006/relationships/package" Target="../embeddings/Microsoft_Word_Document1.docx"/><Relationship Id="rId4" Type="http://schemas.openxmlformats.org/officeDocument/2006/relationships/oleObject" Target="../embeddings/oleObject1.bin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emf"/><Relationship Id="rId3" Type="http://schemas.openxmlformats.org/officeDocument/2006/relationships/image" Target="../media/image13.emf"/><Relationship Id="rId7" Type="http://schemas.openxmlformats.org/officeDocument/2006/relationships/image" Target="../media/image17.emf"/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emf"/><Relationship Id="rId5" Type="http://schemas.openxmlformats.org/officeDocument/2006/relationships/image" Target="../media/image15.emf"/><Relationship Id="rId4" Type="http://schemas.openxmlformats.org/officeDocument/2006/relationships/image" Target="../media/image14.emf"/><Relationship Id="rId9" Type="http://schemas.openxmlformats.org/officeDocument/2006/relationships/image" Target="../media/image19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emf"/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3.emf"/><Relationship Id="rId4" Type="http://schemas.openxmlformats.org/officeDocument/2006/relationships/image" Target="../media/image2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Picture 5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282" t="11667" r="7541" b="14544"/>
          <a:stretch/>
        </p:blipFill>
        <p:spPr bwMode="auto">
          <a:xfrm>
            <a:off x="3373686" y="3284984"/>
            <a:ext cx="2500836" cy="235858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itle 1"/>
          <p:cNvSpPr txBox="1">
            <a:spLocks/>
          </p:cNvSpPr>
          <p:nvPr/>
        </p:nvSpPr>
        <p:spPr>
          <a:xfrm>
            <a:off x="0" y="0"/>
            <a:ext cx="9144000" cy="576064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2500" lnSpcReduction="100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nl-NL" sz="1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nl-NL" sz="18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nl-NL" sz="1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The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sociation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ternal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rth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ight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GA in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hole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udy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pulation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>
            <a:spLocks noChangeArrowheads="1"/>
          </p:cNvSpPr>
          <p:nvPr/>
        </p:nvSpPr>
        <p:spPr bwMode="auto">
          <a:xfrm>
            <a:off x="3009037" y="1255865"/>
            <a:ext cx="50392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0.2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>
            <a:spLocks noChangeArrowheads="1"/>
          </p:cNvSpPr>
          <p:nvPr/>
        </p:nvSpPr>
        <p:spPr bwMode="auto">
          <a:xfrm>
            <a:off x="2973895" y="1735333"/>
            <a:ext cx="56991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0.3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>
            <a:spLocks noChangeArrowheads="1"/>
          </p:cNvSpPr>
          <p:nvPr/>
        </p:nvSpPr>
        <p:spPr bwMode="auto">
          <a:xfrm>
            <a:off x="2973897" y="2202316"/>
            <a:ext cx="56991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0.4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747971" y="476672"/>
            <a:ext cx="353943" cy="224343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nl-NL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rthweight (SD)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>
            <a:spLocks noChangeArrowheads="1"/>
          </p:cNvSpPr>
          <p:nvPr/>
        </p:nvSpPr>
        <p:spPr bwMode="auto">
          <a:xfrm>
            <a:off x="3009036" y="808958"/>
            <a:ext cx="50392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0.1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478989" y="2957707"/>
            <a:ext cx="2436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nl-NL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SD)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3384616" y="2796051"/>
            <a:ext cx="24789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-2                 0                 2                       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3373686" y="5643566"/>
            <a:ext cx="27912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4                -2               0                2                4          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>
            <a:spLocks noChangeArrowheads="1"/>
          </p:cNvSpPr>
          <p:nvPr/>
        </p:nvSpPr>
        <p:spPr bwMode="auto">
          <a:xfrm>
            <a:off x="2987824" y="3689549"/>
            <a:ext cx="50392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>
            <a:spLocks noChangeArrowheads="1"/>
          </p:cNvSpPr>
          <p:nvPr/>
        </p:nvSpPr>
        <p:spPr bwMode="auto">
          <a:xfrm>
            <a:off x="2987824" y="4262899"/>
            <a:ext cx="50392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1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>
            <a:spLocks noChangeArrowheads="1"/>
          </p:cNvSpPr>
          <p:nvPr/>
        </p:nvSpPr>
        <p:spPr bwMode="auto">
          <a:xfrm>
            <a:off x="3013050" y="4841677"/>
            <a:ext cx="50392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7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2800283" y="3284984"/>
            <a:ext cx="353943" cy="230425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nl-NL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isk of SGA (p)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3522506" y="2473890"/>
            <a:ext cx="1013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nl-NL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=0.009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3560748" y="5194584"/>
            <a:ext cx="10130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nl-NL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=0.028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3644684" y="5804630"/>
            <a:ext cx="21118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nl-NL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SD)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Rectangle 27"/>
          <p:cNvSpPr/>
          <p:nvPr/>
        </p:nvSpPr>
        <p:spPr>
          <a:xfrm>
            <a:off x="-20910" y="6106831"/>
            <a:ext cx="9050380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Bef>
                <a:spcPct val="0"/>
              </a:spcBef>
            </a:pP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ots show the </a:t>
            </a: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near and logistic regression models for total </a:t>
            </a:r>
            <a:r>
              <a:rPr lang="en-US" alt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standardized to gestational age; SD) and </a:t>
            </a:r>
            <a:r>
              <a:rPr lang="en-US" altLang="en-US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rthweight</a:t>
            </a: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standardized to gestational age at birth; SD) as </a:t>
            </a: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dicted mean with 95 percent confidence interval. Analyses were performed </a:t>
            </a: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ter </a:t>
            </a: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clusion of </a:t>
            </a:r>
            <a:r>
              <a:rPr lang="en-GB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men with IVF treatment (</a:t>
            </a:r>
            <a:r>
              <a:rPr lang="en-GB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=38), </a:t>
            </a:r>
            <a:r>
              <a:rPr lang="en-GB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win pregnancy (</a:t>
            </a:r>
            <a:r>
              <a:rPr lang="en-GB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=90) and </a:t>
            </a:r>
            <a:r>
              <a:rPr lang="en-GB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adjusted for maternal age, smoking, BMI, parity</a:t>
            </a:r>
            <a:r>
              <a:rPr lang="en-GB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placental weight at birth, </a:t>
            </a:r>
            <a:r>
              <a:rPr lang="en-GB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ducation level, </a:t>
            </a:r>
            <a:r>
              <a:rPr lang="en-GB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hnicity, gestational age at birth, gestational weight gain and </a:t>
            </a:r>
            <a:r>
              <a:rPr lang="en-GB" alt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etal</a:t>
            </a:r>
            <a:r>
              <a:rPr lang="en-GB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x. </a:t>
            </a:r>
            <a:endParaRPr lang="en-US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4" name="Picture 5"/>
          <p:cNvPicPr>
            <a:picLocks noChangeAspect="1" noChangeArrowheads="1"/>
          </p:cNvPicPr>
          <p:nvPr/>
        </p:nvPicPr>
        <p:blipFill rotWithShape="1">
          <a:blip r:embed="rId3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408" t="9320" r="7179" b="11081"/>
          <a:stretch/>
        </p:blipFill>
        <p:spPr bwMode="auto">
          <a:xfrm>
            <a:off x="3398643" y="513845"/>
            <a:ext cx="2454015" cy="233737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1731694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/>
          <p:cNvSpPr txBox="1">
            <a:spLocks/>
          </p:cNvSpPr>
          <p:nvPr/>
        </p:nvSpPr>
        <p:spPr>
          <a:xfrm>
            <a:off x="0" y="0"/>
            <a:ext cx="9144000" cy="57606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nl-NL" sz="1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nl-NL" sz="18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</a:t>
            </a:r>
            <a:r>
              <a:rPr lang="nl-NL" sz="1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4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nl-NL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nl-NL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sociation</a:t>
            </a:r>
            <a:r>
              <a:rPr lang="nl-NL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ternal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nl-NL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asured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the 11th or 12th week </a:t>
            </a:r>
            <a:r>
              <a:rPr lang="nl-NL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nl-NL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GA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atified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etal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x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716015" y="1063769"/>
            <a:ext cx="32403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200" b="1" u="sng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mongst</a:t>
            </a:r>
            <a:r>
              <a:rPr lang="nl-NL" sz="1200" b="1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200" b="1" u="sng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emale</a:t>
            </a:r>
            <a:r>
              <a:rPr lang="nl-NL" sz="1200" b="1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200" b="1" u="sng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etuses</a:t>
            </a:r>
            <a:endParaRPr lang="en-US" sz="1200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1" name="Table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92252696"/>
              </p:ext>
            </p:extLst>
          </p:nvPr>
        </p:nvGraphicFramePr>
        <p:xfrm>
          <a:off x="539552" y="1340768"/>
          <a:ext cx="3312368" cy="2160238"/>
        </p:xfrm>
        <a:graphic>
          <a:graphicData uri="http://schemas.openxmlformats.org/drawingml/2006/table">
            <a:tbl>
              <a:tblPr firstRow="1" firstCol="1" bandRow="1"/>
              <a:tblGrid>
                <a:gridCol w="920102"/>
                <a:gridCol w="644072"/>
                <a:gridCol w="828092"/>
                <a:gridCol w="920102"/>
              </a:tblGrid>
              <a:tr h="36742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 err="1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hCG</a:t>
                      </a:r>
                      <a:r>
                        <a:rPr lang="en-US" sz="1200" b="1" baseline="0" dirty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200" b="1" baseline="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cut-off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OR 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(95%CI)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b="1" i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</a:t>
                      </a:r>
                      <a:r>
                        <a:rPr lang="en-US" sz="1200" b="1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value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98803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b="1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&lt;5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2.08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(0.73-5.92)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b="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0.17</a:t>
                      </a:r>
                      <a:endParaRPr lang="en-US" sz="1200" b="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98803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&lt;10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nl-NL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77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nl-NL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.27-6.02)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200" b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</a:t>
                      </a:r>
                      <a:endParaRPr 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298803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b="1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&lt;15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nl-NL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8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nl-NL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.26-5.28)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200" b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9</a:t>
                      </a:r>
                      <a:endParaRPr 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98803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b="1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&gt;85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nl-NL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9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nl-NL" sz="1200" b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99-1.20)</a:t>
                      </a:r>
                      <a:endParaRPr 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200" b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</a:t>
                      </a:r>
                      <a:endParaRPr 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298803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b="1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&gt;90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nl-NL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3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nl-NL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04-2.96)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2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98803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b="1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&gt;95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0.53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l-NL" sz="120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(0.05-5.24)</a:t>
                      </a:r>
                      <a:endParaRPr lang="en-US" sz="1200" dirty="0" smtClean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b="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0.58</a:t>
                      </a:r>
                      <a:endParaRPr lang="en-US" sz="1200" b="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</a:tbl>
          </a:graphicData>
        </a:graphic>
      </p:graphicFrame>
      <p:graphicFrame>
        <p:nvGraphicFramePr>
          <p:cNvPr id="13" name="Table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34891469"/>
              </p:ext>
            </p:extLst>
          </p:nvPr>
        </p:nvGraphicFramePr>
        <p:xfrm>
          <a:off x="4644008" y="1340768"/>
          <a:ext cx="3312368" cy="2160238"/>
        </p:xfrm>
        <a:graphic>
          <a:graphicData uri="http://schemas.openxmlformats.org/drawingml/2006/table">
            <a:tbl>
              <a:tblPr firstRow="1" firstCol="1" bandRow="1"/>
              <a:tblGrid>
                <a:gridCol w="920102"/>
                <a:gridCol w="644072"/>
                <a:gridCol w="828092"/>
                <a:gridCol w="920102"/>
              </a:tblGrid>
              <a:tr h="36742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 err="1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hCG</a:t>
                      </a:r>
                      <a:r>
                        <a:rPr lang="en-US" sz="1200" b="1" baseline="0" dirty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200" b="1" baseline="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cut-off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OR 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(95%CI)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b="1" i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</a:t>
                      </a:r>
                      <a:r>
                        <a:rPr lang="en-US" sz="1200" b="1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value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98803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b="1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&lt;5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2.39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(0.70-8.07)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b="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0.16</a:t>
                      </a:r>
                      <a:endParaRPr lang="en-US" sz="1200" b="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98803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&lt;10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nl-NL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2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nl-NL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39-3.80)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200" b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3</a:t>
                      </a:r>
                      <a:endParaRPr 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298803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b="1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&lt;15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nl-NL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6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nl-NL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47-2.86)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200" b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6</a:t>
                      </a:r>
                      <a:endParaRPr 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98803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b="1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&gt;85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nl-NL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5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nl-NL" sz="1200" b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35-2.04)</a:t>
                      </a:r>
                      <a:endParaRPr 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200" b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1</a:t>
                      </a:r>
                      <a:endParaRPr 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298803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b="1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&gt;90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nl-NL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4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nl-NL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45-2.93)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8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98803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b="1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&gt;95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1.88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l-NL" sz="120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(0.59-5.93)</a:t>
                      </a:r>
                      <a:endParaRPr lang="en-US" sz="1200" dirty="0" smtClean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b="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0.28</a:t>
                      </a:r>
                      <a:endParaRPr lang="en-US" sz="1200" b="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</a:tbl>
          </a:graphicData>
        </a:graphic>
      </p:graphicFrame>
      <p:sp>
        <p:nvSpPr>
          <p:cNvPr id="7" name="TextBox 8"/>
          <p:cNvSpPr txBox="1"/>
          <p:nvPr/>
        </p:nvSpPr>
        <p:spPr>
          <a:xfrm>
            <a:off x="539552" y="1052736"/>
            <a:ext cx="32403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200" b="1" u="sng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mongst</a:t>
            </a:r>
            <a:r>
              <a:rPr lang="nl-NL" sz="1200" b="1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ale </a:t>
            </a:r>
            <a:r>
              <a:rPr lang="nl-NL" sz="1200" b="1" u="sng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etuses</a:t>
            </a:r>
            <a:endParaRPr lang="en-US" sz="1200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Rectangle 27"/>
          <p:cNvSpPr/>
          <p:nvPr/>
        </p:nvSpPr>
        <p:spPr>
          <a:xfrm>
            <a:off x="-27410" y="3739679"/>
            <a:ext cx="9171409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Bef>
                <a:spcPct val="0"/>
              </a:spcBef>
            </a:pP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shows the association between different cut-off levels for total </a:t>
            </a:r>
            <a:r>
              <a:rPr lang="en-US" alt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standardized to gestational age; SD) and small for </a:t>
            </a: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stational age (defined as birthweight below 10</a:t>
            </a:r>
            <a:r>
              <a:rPr lang="en-US" alt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ercentile for gestational age) as </a:t>
            </a: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dds ratio </a:t>
            </a: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95 percent confidence interval. Analyses were performed </a:t>
            </a: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ter </a:t>
            </a: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clusion of </a:t>
            </a:r>
            <a:r>
              <a:rPr lang="en-GB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men with IVF treatment (</a:t>
            </a:r>
            <a:r>
              <a:rPr lang="en-GB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=38), </a:t>
            </a:r>
            <a:r>
              <a:rPr lang="en-GB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win pregnancy (</a:t>
            </a:r>
            <a:r>
              <a:rPr lang="en-GB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=90) and </a:t>
            </a:r>
            <a:r>
              <a:rPr lang="en-GB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adjusted for maternal age, smoking, BMI, parity</a:t>
            </a:r>
            <a:r>
              <a:rPr lang="en-GB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placental weight at birth, </a:t>
            </a:r>
            <a:r>
              <a:rPr lang="en-GB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ducation level, </a:t>
            </a:r>
            <a:r>
              <a:rPr lang="en-GB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hnicity, gestational age at birth, gestational weight gain and </a:t>
            </a:r>
            <a:r>
              <a:rPr lang="en-GB" alt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etal</a:t>
            </a:r>
            <a:r>
              <a:rPr lang="en-GB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x. </a:t>
            </a:r>
            <a:endParaRPr lang="en-US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516101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69523570"/>
              </p:ext>
            </p:extLst>
          </p:nvPr>
        </p:nvGraphicFramePr>
        <p:xfrm>
          <a:off x="1223628" y="692696"/>
          <a:ext cx="6696744" cy="2051765"/>
        </p:xfrm>
        <a:graphic>
          <a:graphicData uri="http://schemas.openxmlformats.org/drawingml/2006/table">
            <a:tbl>
              <a:tblPr firstRow="1" firstCol="1" bandRow="1"/>
              <a:tblGrid>
                <a:gridCol w="1803676"/>
                <a:gridCol w="941048"/>
                <a:gridCol w="719405"/>
                <a:gridCol w="754373"/>
                <a:gridCol w="1239121"/>
                <a:gridCol w="1239121"/>
              </a:tblGrid>
              <a:tr h="36000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b="1" i="0" baseline="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Week of </a:t>
                      </a:r>
                      <a:r>
                        <a:rPr lang="nl-NL" sz="1200" b="1" i="0" baseline="0" dirty="0" err="1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hCG</a:t>
                      </a:r>
                      <a:r>
                        <a:rPr lang="nl-NL" sz="1200" b="1" i="0" baseline="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nl-NL" sz="1200" b="1" i="0" baseline="0" dirty="0" err="1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measurement</a:t>
                      </a:r>
                      <a:endParaRPr lang="en-US" sz="1200" b="1" i="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b="1" i="0" dirty="0" err="1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Fetal</a:t>
                      </a:r>
                      <a:r>
                        <a:rPr lang="nl-NL" sz="1200" b="1" i="0" baseline="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nl-NL" sz="1200" b="1" i="0" baseline="0" dirty="0" err="1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sex</a:t>
                      </a:r>
                      <a:endParaRPr lang="en-US" sz="1200" b="1" i="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l-NL" sz="1200" b="1" i="0" dirty="0" err="1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Beta</a:t>
                      </a:r>
                      <a:endParaRPr lang="en-US" sz="1200" b="1" i="0" dirty="0" smtClean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l-NL" sz="1200" b="1" i="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±SE</a:t>
                      </a:r>
                      <a:endParaRPr lang="en-US" sz="1200" b="1" i="0" dirty="0" smtClean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i="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P-value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i="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95%</a:t>
                      </a:r>
                      <a:r>
                        <a:rPr lang="en-US" sz="1200" b="1" i="0" baseline="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200" b="1" i="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Confidence interval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</a:tr>
              <a:tr h="387529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b="0" i="0" baseline="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All</a:t>
                      </a:r>
                      <a:r>
                        <a:rPr lang="nl-NL" sz="1200" b="0" i="0" baseline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 weeks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b="0" i="0" baseline="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male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sz="1200" b="0" i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2</a:t>
                      </a:r>
                      <a:endParaRPr lang="en-US" sz="1200" b="0" i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nl-NL" sz="1200" b="0" i="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±</a:t>
                      </a:r>
                      <a:r>
                        <a:rPr lang="en-US" sz="1200" b="0" i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9</a:t>
                      </a:r>
                      <a:endParaRPr lang="en-US" sz="1200" b="0" i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</a:t>
                      </a:r>
                      <a:endParaRPr lang="en-US" sz="1200" b="0" i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-0.000, 0.003)</a:t>
                      </a:r>
                      <a:endParaRPr lang="en-US" sz="1200" b="0" i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</a:tr>
              <a:tr h="288032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2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11</a:t>
                      </a:r>
                      <a:r>
                        <a:rPr kumimoji="0" lang="en-US" sz="1200" b="0" i="0" u="none" strike="noStrike" kern="1200" cap="none" spc="0" normalizeH="0" baseline="3000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th</a:t>
                      </a:r>
                      <a:r>
                        <a:rPr kumimoji="0" lang="en-US" sz="12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 and 12</a:t>
                      </a:r>
                      <a:r>
                        <a:rPr kumimoji="0" lang="en-US" sz="1200" b="0" i="0" u="none" strike="noStrike" kern="1200" cap="none" spc="0" normalizeH="0" baseline="3000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th</a:t>
                      </a:r>
                      <a:r>
                        <a:rPr kumimoji="0" lang="en-US" sz="12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 week only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b="0" i="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male</a:t>
                      </a:r>
                      <a:endParaRPr lang="en-US" sz="1200" b="0" i="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b="0" i="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0.003</a:t>
                      </a:r>
                      <a:endParaRPr lang="en-US" sz="1200" b="0" i="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b="0" i="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±0.002</a:t>
                      </a:r>
                      <a:endParaRPr lang="en-US" sz="1200" b="0" i="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b="0" i="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0.19</a:t>
                      </a:r>
                      <a:endParaRPr lang="en-US" sz="1200" b="0" i="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(-0.002, 0.007)</a:t>
                      </a:r>
                      <a:endParaRPr lang="en-US" sz="1200" b="0" i="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</a:tr>
              <a:tr h="288032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1200" b="0" i="1" u="none" strike="noStrike" kern="1200" cap="none" spc="0" normalizeH="0" baseline="0" noProof="0" dirty="0" smtClean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1200" b="0" i="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1200" b="0" i="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1200" b="0" i="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1200" b="0" i="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1200" b="0" i="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</a:tr>
              <a:tr h="322886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b="0" i="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All</a:t>
                      </a:r>
                      <a:r>
                        <a:rPr lang="nl-NL" sz="1200" b="0" i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 weeks</a:t>
                      </a:r>
                      <a:endParaRPr lang="en-US" sz="1200" b="0" i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b="0" i="0" dirty="0" err="1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female</a:t>
                      </a:r>
                      <a:endParaRPr lang="en-US" sz="1200" b="0" i="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0.002</a:t>
                      </a:r>
                      <a:endParaRPr lang="en-US" sz="1200" b="0" i="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b="0" i="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±</a:t>
                      </a:r>
                      <a:r>
                        <a:rPr lang="en-US" sz="1200" b="0" i="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0.001</a:t>
                      </a:r>
                      <a:endParaRPr lang="en-US" sz="1200" b="0" i="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0.0075</a:t>
                      </a:r>
                      <a:endParaRPr lang="en-US" sz="1200" b="0" i="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(0.001, 0.004)</a:t>
                      </a:r>
                      <a:endParaRPr lang="en-US" sz="1200" b="0" i="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</a:tr>
              <a:tr h="344662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11</a:t>
                      </a:r>
                      <a:r>
                        <a:rPr lang="en-US" sz="1200" b="0" i="0" baseline="30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th</a:t>
                      </a:r>
                      <a:r>
                        <a:rPr lang="en-US" sz="1200" b="0" i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 and 12</a:t>
                      </a:r>
                      <a:r>
                        <a:rPr lang="en-US" sz="1200" b="0" i="0" baseline="30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th</a:t>
                      </a:r>
                      <a:r>
                        <a:rPr lang="en-US" sz="1200" b="0" i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 week only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200" b="0" i="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US" sz="1200" b="0" i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nl-NL" sz="1200" b="0" i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</a:t>
                      </a:r>
                      <a:endParaRPr lang="en-US" sz="1200" b="0" i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nl-NL" sz="1200" b="0" i="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±0.002</a:t>
                      </a:r>
                      <a:endParaRPr lang="en-US" sz="1200" b="0" i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200" b="0" i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</a:t>
                      </a:r>
                      <a:endParaRPr lang="en-US" sz="1200" b="0" i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002, 0.010)</a:t>
                      </a:r>
                      <a:endParaRPr lang="en-US" sz="1200" b="0" i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00"/>
                    </a:solidFill>
                  </a:tcPr>
                </a:tc>
              </a:tr>
            </a:tbl>
          </a:graphicData>
        </a:graphic>
      </p:graphicFrame>
      <p:sp>
        <p:nvSpPr>
          <p:cNvPr id="10" name="Title 1"/>
          <p:cNvSpPr txBox="1">
            <a:spLocks/>
          </p:cNvSpPr>
          <p:nvPr/>
        </p:nvSpPr>
        <p:spPr>
          <a:xfrm>
            <a:off x="0" y="0"/>
            <a:ext cx="9144000" cy="57606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nl-NL" sz="1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nl-NL" sz="18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</a:t>
            </a:r>
            <a:r>
              <a:rPr lang="nl-NL" sz="1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5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The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sociation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ternal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etal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owth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roughout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station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atified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etal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x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0" y="2924944"/>
            <a:ext cx="9144000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Bef>
                <a:spcPct val="0"/>
              </a:spcBef>
            </a:pPr>
            <a:r>
              <a:rPr lang="en-US" altLang="en-US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able shows the repeated measurement model for the association of total </a:t>
            </a:r>
            <a:r>
              <a:rPr lang="en-US" altLang="en-US" sz="110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en-US" altLang="en-US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SD), fetal weight (measured twice during pregnancy) and birthweight, as </a:t>
            </a:r>
            <a:r>
              <a:rPr lang="en-US" altLang="en-US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dicted mean with 95 percent confidence interval. Analyses were performed </a:t>
            </a:r>
            <a:r>
              <a:rPr lang="en-US" altLang="en-US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fter </a:t>
            </a:r>
            <a:r>
              <a:rPr lang="en-US" altLang="en-US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clusion of </a:t>
            </a:r>
            <a:r>
              <a:rPr lang="en-GB" altLang="en-US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omen with IVF treatment (</a:t>
            </a:r>
            <a:r>
              <a:rPr lang="en-GB" altLang="en-US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=38), </a:t>
            </a:r>
            <a:r>
              <a:rPr lang="en-GB" altLang="en-US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win pregnancy (</a:t>
            </a:r>
            <a:r>
              <a:rPr lang="en-GB" altLang="en-US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=90) and </a:t>
            </a:r>
            <a:r>
              <a:rPr lang="en-GB" altLang="en-US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ere adjusted for maternal age, smoking, BMI, parity, education level, </a:t>
            </a:r>
            <a:r>
              <a:rPr lang="en-GB" altLang="en-US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thnicity, gestational weight gain and placental weight at birth.</a:t>
            </a:r>
            <a:endParaRPr lang="en-US" altLang="en-US" sz="1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338313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58197411"/>
              </p:ext>
            </p:extLst>
          </p:nvPr>
        </p:nvGraphicFramePr>
        <p:xfrm>
          <a:off x="2555775" y="576064"/>
          <a:ext cx="3168353" cy="1944216"/>
        </p:xfrm>
        <a:graphic>
          <a:graphicData uri="http://schemas.openxmlformats.org/drawingml/2006/table">
            <a:tbl>
              <a:tblPr firstRow="1" firstCol="1" bandRow="1"/>
              <a:tblGrid>
                <a:gridCol w="1008112"/>
                <a:gridCol w="488055"/>
                <a:gridCol w="880097"/>
                <a:gridCol w="792089"/>
              </a:tblGrid>
              <a:tr h="330678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 err="1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hCG</a:t>
                      </a:r>
                      <a:r>
                        <a:rPr lang="en-US" sz="1200" b="1" baseline="0" dirty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200" b="1" baseline="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cut-off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OR 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(95%CI)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b="1" i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</a:t>
                      </a:r>
                      <a:r>
                        <a:rPr lang="en-US" sz="1200" b="1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value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68923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b="1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&lt;5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1.24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(0.88-1.75)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b="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0.22</a:t>
                      </a:r>
                      <a:endParaRPr lang="en-US" sz="1200" b="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68923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&lt;10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7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82-1.39)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1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268923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b="1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&lt;15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8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95-1.47)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200" b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4</a:t>
                      </a:r>
                      <a:endParaRPr 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68923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b="1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&gt;85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8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200" b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86-1.35)</a:t>
                      </a:r>
                      <a:endParaRPr 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200" b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2</a:t>
                      </a:r>
                      <a:endParaRPr 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268923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b="1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&gt;90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6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81-1.37)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9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68923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b="1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&gt;95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1.18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l-NL" sz="120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(0.84-1.66)</a:t>
                      </a:r>
                      <a:endParaRPr lang="en-US" sz="1200" dirty="0" smtClean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b="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0.34</a:t>
                      </a:r>
                      <a:endParaRPr lang="en-US" sz="1200" b="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</a:tbl>
          </a:graphicData>
        </a:graphic>
      </p:graphicFrame>
      <p:sp>
        <p:nvSpPr>
          <p:cNvPr id="5" name="Title 1"/>
          <p:cNvSpPr txBox="1">
            <a:spLocks/>
          </p:cNvSpPr>
          <p:nvPr/>
        </p:nvSpPr>
        <p:spPr>
          <a:xfrm>
            <a:off x="0" y="0"/>
            <a:ext cx="9144000" cy="57606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nl-NL" sz="1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nl-NL" sz="18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</a:t>
            </a:r>
            <a:r>
              <a:rPr lang="nl-NL" sz="1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The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sociation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ternal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ut-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fs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GA.</a:t>
            </a:r>
            <a:endParaRPr 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ctangle 27"/>
          <p:cNvSpPr/>
          <p:nvPr/>
        </p:nvSpPr>
        <p:spPr>
          <a:xfrm>
            <a:off x="0" y="2708920"/>
            <a:ext cx="9144000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Bef>
                <a:spcPct val="0"/>
              </a:spcBef>
            </a:pP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shows the association between different cut-off levels for total </a:t>
            </a:r>
            <a:r>
              <a:rPr lang="en-US" alt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standardized to gestational age; SD) and small for </a:t>
            </a: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stational age (defined as birthweight below 10</a:t>
            </a:r>
            <a:r>
              <a:rPr lang="en-US" alt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ercentile for gestational age) as </a:t>
            </a: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dds ratio </a:t>
            </a: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95 percent confidence interval. Analyses were performed </a:t>
            </a: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ter </a:t>
            </a: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clusion of </a:t>
            </a:r>
            <a:r>
              <a:rPr lang="en-GB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men with IVF treatment (</a:t>
            </a:r>
            <a:r>
              <a:rPr lang="en-GB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=38), </a:t>
            </a:r>
            <a:r>
              <a:rPr lang="en-GB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win pregnancy (</a:t>
            </a:r>
            <a:r>
              <a:rPr lang="en-GB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=90) and </a:t>
            </a:r>
            <a:r>
              <a:rPr lang="en-GB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adjusted for maternal age, smoking, BMI, parity</a:t>
            </a:r>
            <a:r>
              <a:rPr lang="en-GB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placental weight at birth, </a:t>
            </a:r>
            <a:r>
              <a:rPr lang="en-GB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ducation level, </a:t>
            </a:r>
            <a:r>
              <a:rPr lang="en-GB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hnicity, gestational age at birth, gestational weight gain and </a:t>
            </a:r>
            <a:r>
              <a:rPr lang="en-GB" alt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etal</a:t>
            </a:r>
            <a:r>
              <a:rPr lang="en-GB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x. </a:t>
            </a:r>
            <a:endParaRPr lang="en-US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141221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 txBox="1">
            <a:spLocks/>
          </p:cNvSpPr>
          <p:nvPr/>
        </p:nvSpPr>
        <p:spPr>
          <a:xfrm>
            <a:off x="0" y="-11472"/>
            <a:ext cx="9143999" cy="57606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nl-NL" sz="1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nl-NL" sz="18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nl-NL" sz="1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2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The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sociation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ternal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rth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ight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atified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stational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ge</a:t>
            </a:r>
            <a:r>
              <a:rPr lang="nl-NL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asurement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5514195" y="2899033"/>
            <a:ext cx="20857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-</a:t>
            </a:r>
            <a:r>
              <a:rPr lang="nl-NL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                0                2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>
            <a:spLocks noChangeArrowheads="1"/>
          </p:cNvSpPr>
          <p:nvPr/>
        </p:nvSpPr>
        <p:spPr bwMode="auto">
          <a:xfrm>
            <a:off x="5054510" y="1369260"/>
            <a:ext cx="48569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>
            <a:spLocks noChangeArrowheads="1"/>
          </p:cNvSpPr>
          <p:nvPr/>
        </p:nvSpPr>
        <p:spPr bwMode="auto">
          <a:xfrm>
            <a:off x="5030812" y="1753724"/>
            <a:ext cx="54930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>
            <a:spLocks noChangeArrowheads="1"/>
          </p:cNvSpPr>
          <p:nvPr/>
        </p:nvSpPr>
        <p:spPr bwMode="auto">
          <a:xfrm>
            <a:off x="5013974" y="2185977"/>
            <a:ext cx="54930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>
            <a:spLocks noChangeArrowheads="1"/>
          </p:cNvSpPr>
          <p:nvPr/>
        </p:nvSpPr>
        <p:spPr bwMode="auto">
          <a:xfrm>
            <a:off x="5013974" y="2599723"/>
            <a:ext cx="54930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1848563" y="564592"/>
            <a:ext cx="217503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100" u="sng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stational</a:t>
            </a:r>
            <a:r>
              <a:rPr lang="nl-NL" sz="1100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100" u="sng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ge</a:t>
            </a:r>
            <a:r>
              <a:rPr lang="nl-NL" sz="1100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4.5 - 12 weeks</a:t>
            </a:r>
            <a:endParaRPr lang="en-US" sz="1100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5411733" y="588429"/>
            <a:ext cx="21602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100" u="sng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stational</a:t>
            </a:r>
            <a:r>
              <a:rPr lang="nl-NL" sz="1100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100" u="sng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ge</a:t>
            </a:r>
            <a:r>
              <a:rPr lang="nl-NL" sz="1100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2 – 13.5 weeks</a:t>
            </a:r>
            <a:endParaRPr lang="en-US" sz="1100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4837002" y="841945"/>
            <a:ext cx="353943" cy="199468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nl-NL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rthweight (SD)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1834956" y="3028747"/>
            <a:ext cx="220224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1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nl-NL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SD)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0" y="6087963"/>
            <a:ext cx="9144000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Bef>
                <a:spcPct val="0"/>
              </a:spcBef>
            </a:pP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ots show the </a:t>
            </a: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near regression model for the relationship </a:t>
            </a: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tween total </a:t>
            </a: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ternal </a:t>
            </a:r>
            <a:r>
              <a:rPr lang="en-US" altLang="en-US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standardized to gestational age at measurement; SD) and </a:t>
            </a:r>
            <a:r>
              <a:rPr lang="en-US" altLang="en-US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rthweight</a:t>
            </a: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standardized to gestational age at birth; SD) as </a:t>
            </a: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dicted mean with 95 percent confidence interval. Analyses were performed </a:t>
            </a: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ter </a:t>
            </a: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clusion of </a:t>
            </a:r>
            <a:r>
              <a:rPr lang="en-GB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men with IVF treatment (</a:t>
            </a:r>
            <a:r>
              <a:rPr lang="en-GB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=38), </a:t>
            </a:r>
            <a:r>
              <a:rPr lang="en-GB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win pregnancy (</a:t>
            </a:r>
            <a:r>
              <a:rPr lang="en-GB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=90) </a:t>
            </a:r>
            <a:r>
              <a:rPr lang="en-GB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were adjusted for maternal age, smoking, BMI, parity</a:t>
            </a:r>
            <a:r>
              <a:rPr lang="en-GB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placental weight at birth, education </a:t>
            </a:r>
            <a:r>
              <a:rPr lang="en-GB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vel, </a:t>
            </a:r>
            <a:r>
              <a:rPr lang="en-GB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hnicity,  gestational age at birth, gestational weight gain and </a:t>
            </a:r>
            <a:r>
              <a:rPr lang="en-GB" alt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etal</a:t>
            </a:r>
            <a:r>
              <a:rPr lang="en-GB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x. </a:t>
            </a:r>
            <a:endParaRPr lang="en-US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TextBox 40"/>
          <p:cNvSpPr txBox="1">
            <a:spLocks noChangeArrowheads="1"/>
          </p:cNvSpPr>
          <p:nvPr/>
        </p:nvSpPr>
        <p:spPr bwMode="auto">
          <a:xfrm>
            <a:off x="5088439" y="940167"/>
            <a:ext cx="48569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4" name="Picture 5"/>
          <p:cNvPicPr>
            <a:picLocks noChangeAspect="1" noChangeArrowheads="1"/>
          </p:cNvPicPr>
          <p:nvPr/>
        </p:nvPicPr>
        <p:blipFill rotWithShape="1">
          <a:blip r:embed="rId2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941" t="7352" r="6761" b="9780"/>
          <a:stretch/>
        </p:blipFill>
        <p:spPr bwMode="auto">
          <a:xfrm>
            <a:off x="5427385" y="855357"/>
            <a:ext cx="2180157" cy="210055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7" name="Picture 3"/>
          <p:cNvPicPr>
            <a:picLocks noChangeAspect="1" noChangeArrowheads="1"/>
          </p:cNvPicPr>
          <p:nvPr/>
        </p:nvPicPr>
        <p:blipFill rotWithShape="1">
          <a:blip r:embed="rId3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93" t="7563" r="6246" b="10259"/>
          <a:stretch/>
        </p:blipFill>
        <p:spPr bwMode="auto">
          <a:xfrm>
            <a:off x="1834752" y="852389"/>
            <a:ext cx="2177595" cy="207487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8" name="TextBox 27"/>
          <p:cNvSpPr txBox="1"/>
          <p:nvPr/>
        </p:nvSpPr>
        <p:spPr>
          <a:xfrm>
            <a:off x="1281952" y="841945"/>
            <a:ext cx="353943" cy="199468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nl-NL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rthweight (SD)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/>
          <p:cNvSpPr txBox="1">
            <a:spLocks noChangeArrowheads="1"/>
          </p:cNvSpPr>
          <p:nvPr/>
        </p:nvSpPr>
        <p:spPr bwMode="auto">
          <a:xfrm>
            <a:off x="1480417" y="1281150"/>
            <a:ext cx="48569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30"/>
          <p:cNvSpPr txBox="1">
            <a:spLocks noChangeArrowheads="1"/>
          </p:cNvSpPr>
          <p:nvPr/>
        </p:nvSpPr>
        <p:spPr bwMode="auto">
          <a:xfrm>
            <a:off x="1420735" y="1618112"/>
            <a:ext cx="54930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31"/>
          <p:cNvSpPr txBox="1">
            <a:spLocks noChangeArrowheads="1"/>
          </p:cNvSpPr>
          <p:nvPr/>
        </p:nvSpPr>
        <p:spPr bwMode="auto">
          <a:xfrm>
            <a:off x="1427300" y="1980700"/>
            <a:ext cx="54930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Box 34"/>
          <p:cNvSpPr txBox="1">
            <a:spLocks noChangeArrowheads="1"/>
          </p:cNvSpPr>
          <p:nvPr/>
        </p:nvSpPr>
        <p:spPr bwMode="auto">
          <a:xfrm>
            <a:off x="1430412" y="2362552"/>
            <a:ext cx="54930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36"/>
          <p:cNvSpPr txBox="1">
            <a:spLocks noChangeArrowheads="1"/>
          </p:cNvSpPr>
          <p:nvPr/>
        </p:nvSpPr>
        <p:spPr bwMode="auto">
          <a:xfrm>
            <a:off x="1490904" y="914332"/>
            <a:ext cx="48569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1814054" y="2888537"/>
            <a:ext cx="21775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-</a:t>
            </a:r>
            <a:r>
              <a:rPr lang="nl-NL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               0                2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5427385" y="3045227"/>
            <a:ext cx="220224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1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nl-NL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SD)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2" name="Picture 3"/>
          <p:cNvPicPr>
            <a:picLocks noChangeAspect="1" noChangeArrowheads="1"/>
          </p:cNvPicPr>
          <p:nvPr/>
        </p:nvPicPr>
        <p:blipFill rotWithShape="1">
          <a:blip r:embed="rId4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144" t="7541" r="7488" b="9849"/>
          <a:stretch/>
        </p:blipFill>
        <p:spPr bwMode="auto">
          <a:xfrm>
            <a:off x="803353" y="3651184"/>
            <a:ext cx="2178902" cy="20966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8" name="TextBox 47"/>
          <p:cNvSpPr txBox="1"/>
          <p:nvPr/>
        </p:nvSpPr>
        <p:spPr>
          <a:xfrm>
            <a:off x="897299" y="5362780"/>
            <a:ext cx="7048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nl-NL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=0.65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TextBox 48"/>
          <p:cNvSpPr txBox="1">
            <a:spLocks noChangeArrowheads="1"/>
          </p:cNvSpPr>
          <p:nvPr/>
        </p:nvSpPr>
        <p:spPr bwMode="auto">
          <a:xfrm>
            <a:off x="3101372" y="4054954"/>
            <a:ext cx="48569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TextBox 52"/>
          <p:cNvSpPr txBox="1">
            <a:spLocks noChangeArrowheads="1"/>
          </p:cNvSpPr>
          <p:nvPr/>
        </p:nvSpPr>
        <p:spPr bwMode="auto">
          <a:xfrm>
            <a:off x="3049689" y="4452159"/>
            <a:ext cx="54930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TextBox 53"/>
          <p:cNvSpPr txBox="1">
            <a:spLocks noChangeArrowheads="1"/>
          </p:cNvSpPr>
          <p:nvPr/>
        </p:nvSpPr>
        <p:spPr bwMode="auto">
          <a:xfrm>
            <a:off x="3040757" y="4905560"/>
            <a:ext cx="54930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TextBox 54"/>
          <p:cNvSpPr txBox="1">
            <a:spLocks noChangeArrowheads="1"/>
          </p:cNvSpPr>
          <p:nvPr/>
        </p:nvSpPr>
        <p:spPr bwMode="auto">
          <a:xfrm>
            <a:off x="3045805" y="5310043"/>
            <a:ext cx="54930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2872717" y="3651184"/>
            <a:ext cx="353943" cy="199468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nl-NL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rthweight (SD)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TextBox 56"/>
          <p:cNvSpPr txBox="1">
            <a:spLocks noChangeArrowheads="1"/>
          </p:cNvSpPr>
          <p:nvPr/>
        </p:nvSpPr>
        <p:spPr bwMode="auto">
          <a:xfrm>
            <a:off x="3103332" y="3651184"/>
            <a:ext cx="48569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TextBox 57"/>
          <p:cNvSpPr txBox="1">
            <a:spLocks noChangeArrowheads="1"/>
          </p:cNvSpPr>
          <p:nvPr/>
        </p:nvSpPr>
        <p:spPr bwMode="auto">
          <a:xfrm>
            <a:off x="453279" y="4054954"/>
            <a:ext cx="48569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TextBox 58"/>
          <p:cNvSpPr txBox="1">
            <a:spLocks noChangeArrowheads="1"/>
          </p:cNvSpPr>
          <p:nvPr/>
        </p:nvSpPr>
        <p:spPr bwMode="auto">
          <a:xfrm>
            <a:off x="407126" y="4400732"/>
            <a:ext cx="54930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TextBox 59"/>
          <p:cNvSpPr txBox="1">
            <a:spLocks noChangeArrowheads="1"/>
          </p:cNvSpPr>
          <p:nvPr/>
        </p:nvSpPr>
        <p:spPr bwMode="auto">
          <a:xfrm>
            <a:off x="389675" y="4773273"/>
            <a:ext cx="54930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TextBox 60"/>
          <p:cNvSpPr txBox="1">
            <a:spLocks noChangeArrowheads="1"/>
          </p:cNvSpPr>
          <p:nvPr/>
        </p:nvSpPr>
        <p:spPr bwMode="auto">
          <a:xfrm>
            <a:off x="380358" y="5151963"/>
            <a:ext cx="54930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187709" y="3625645"/>
            <a:ext cx="353943" cy="199468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nl-NL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rthweight (SD)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TextBox 62"/>
          <p:cNvSpPr txBox="1">
            <a:spLocks noChangeArrowheads="1"/>
          </p:cNvSpPr>
          <p:nvPr/>
        </p:nvSpPr>
        <p:spPr bwMode="auto">
          <a:xfrm>
            <a:off x="438928" y="3701000"/>
            <a:ext cx="48569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818549" y="5646058"/>
            <a:ext cx="21775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-</a:t>
            </a:r>
            <a:r>
              <a:rPr lang="nl-NL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                 0                 2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838509" y="5843027"/>
            <a:ext cx="220224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1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nl-NL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SD)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838741" y="3323058"/>
            <a:ext cx="21582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100" u="sng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stational</a:t>
            </a:r>
            <a:r>
              <a:rPr lang="nl-NL" sz="1100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100" u="sng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ge</a:t>
            </a:r>
            <a:r>
              <a:rPr lang="nl-NL" sz="1100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3.5 – 15.5 weeks</a:t>
            </a:r>
            <a:endParaRPr lang="en-US" sz="1100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7" name="Picture 4"/>
          <p:cNvPicPr>
            <a:picLocks noChangeAspect="1" noChangeArrowheads="1"/>
          </p:cNvPicPr>
          <p:nvPr/>
        </p:nvPicPr>
        <p:blipFill rotWithShape="1">
          <a:blip r:embed="rId5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96" t="11130" r="6720" b="9967"/>
          <a:stretch/>
        </p:blipFill>
        <p:spPr bwMode="auto">
          <a:xfrm>
            <a:off x="3438335" y="3684840"/>
            <a:ext cx="2173710" cy="206304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8" name="TextBox 67"/>
          <p:cNvSpPr txBox="1"/>
          <p:nvPr/>
        </p:nvSpPr>
        <p:spPr>
          <a:xfrm>
            <a:off x="3470876" y="5843027"/>
            <a:ext cx="220224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1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nl-NL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SD)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3470876" y="5691510"/>
            <a:ext cx="21775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-</a:t>
            </a:r>
            <a:r>
              <a:rPr lang="nl-NL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               0                2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3480533" y="3323058"/>
            <a:ext cx="21582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100" u="sng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stational</a:t>
            </a:r>
            <a:r>
              <a:rPr lang="nl-NL" sz="1100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100" u="sng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ge</a:t>
            </a:r>
            <a:r>
              <a:rPr lang="nl-NL" sz="1100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15.5 – 19.5 weeks</a:t>
            </a:r>
            <a:endParaRPr lang="en-US" sz="1100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1" name="Picture 2"/>
          <p:cNvPicPr>
            <a:picLocks noChangeAspect="1" noChangeArrowheads="1"/>
          </p:cNvPicPr>
          <p:nvPr/>
        </p:nvPicPr>
        <p:blipFill rotWithShape="1">
          <a:blip r:embed="rId6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87" t="8384" r="8616" b="9754"/>
          <a:stretch/>
        </p:blipFill>
        <p:spPr bwMode="auto">
          <a:xfrm>
            <a:off x="6191381" y="3697169"/>
            <a:ext cx="2072726" cy="206397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2" name="TextBox 71"/>
          <p:cNvSpPr txBox="1"/>
          <p:nvPr/>
        </p:nvSpPr>
        <p:spPr>
          <a:xfrm>
            <a:off x="6218764" y="5691509"/>
            <a:ext cx="21775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-</a:t>
            </a:r>
            <a:r>
              <a:rPr lang="nl-NL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               0                2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TextBox 72"/>
          <p:cNvSpPr txBox="1">
            <a:spLocks noChangeArrowheads="1"/>
          </p:cNvSpPr>
          <p:nvPr/>
        </p:nvSpPr>
        <p:spPr bwMode="auto">
          <a:xfrm>
            <a:off x="5825481" y="4167928"/>
            <a:ext cx="48569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TextBox 73"/>
          <p:cNvSpPr txBox="1">
            <a:spLocks noChangeArrowheads="1"/>
          </p:cNvSpPr>
          <p:nvPr/>
        </p:nvSpPr>
        <p:spPr bwMode="auto">
          <a:xfrm>
            <a:off x="5761877" y="4577861"/>
            <a:ext cx="54930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TextBox 74"/>
          <p:cNvSpPr txBox="1">
            <a:spLocks noChangeArrowheads="1"/>
          </p:cNvSpPr>
          <p:nvPr/>
        </p:nvSpPr>
        <p:spPr bwMode="auto">
          <a:xfrm>
            <a:off x="5751016" y="5019070"/>
            <a:ext cx="54930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TextBox 75"/>
          <p:cNvSpPr txBox="1">
            <a:spLocks noChangeArrowheads="1"/>
          </p:cNvSpPr>
          <p:nvPr/>
        </p:nvSpPr>
        <p:spPr bwMode="auto">
          <a:xfrm>
            <a:off x="5751016" y="5428962"/>
            <a:ext cx="54930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TextBox 76"/>
          <p:cNvSpPr txBox="1">
            <a:spLocks noChangeArrowheads="1"/>
          </p:cNvSpPr>
          <p:nvPr/>
        </p:nvSpPr>
        <p:spPr bwMode="auto">
          <a:xfrm>
            <a:off x="5825481" y="3723613"/>
            <a:ext cx="48569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6218764" y="3338396"/>
            <a:ext cx="211378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100" u="sng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stational</a:t>
            </a:r>
            <a:r>
              <a:rPr lang="nl-NL" sz="1100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100" u="sng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ge</a:t>
            </a:r>
            <a:r>
              <a:rPr lang="nl-NL" sz="1100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19.5 – 39 weeks</a:t>
            </a:r>
            <a:endParaRPr lang="en-US" sz="1100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3598989" y="5384291"/>
            <a:ext cx="7048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nl-NL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=0.73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6289810" y="5417928"/>
            <a:ext cx="7048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nl-NL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=0.77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5638812" y="2606715"/>
            <a:ext cx="7048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nl-NL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=0.84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1979712" y="2572480"/>
            <a:ext cx="7048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nl-NL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=0.005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5604329" y="3675013"/>
            <a:ext cx="353943" cy="199468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nl-NL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rthweight (SD)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6206437" y="5864622"/>
            <a:ext cx="220224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1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nl-NL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SD)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067743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itle 1"/>
          <p:cNvSpPr txBox="1">
            <a:spLocks/>
          </p:cNvSpPr>
          <p:nvPr/>
        </p:nvSpPr>
        <p:spPr>
          <a:xfrm>
            <a:off x="0" y="0"/>
            <a:ext cx="9144000" cy="57606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nl-NL" sz="1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nl-NL" sz="18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nl-NL" sz="1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3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The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sociation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asured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the 11th or 12th week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rth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ight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GA.</a:t>
            </a:r>
            <a:endParaRPr 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Rectangle 30"/>
          <p:cNvSpPr/>
          <p:nvPr/>
        </p:nvSpPr>
        <p:spPr>
          <a:xfrm>
            <a:off x="0" y="6165304"/>
            <a:ext cx="9050380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Bef>
                <a:spcPct val="0"/>
              </a:spcBef>
            </a:pP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ots show the </a:t>
            </a: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near and logistic regression models for total </a:t>
            </a:r>
            <a:r>
              <a:rPr lang="en-US" alt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standardized to gestational age at measurement; SD) and </a:t>
            </a:r>
            <a:r>
              <a:rPr lang="en-US" altLang="en-US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rthweight</a:t>
            </a: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standardized to gestational age at birth; SD) as </a:t>
            </a: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dicted mean with </a:t>
            </a: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5 </a:t>
            </a: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cent confidence interval. Analyses were performed </a:t>
            </a: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ter </a:t>
            </a: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clusion of </a:t>
            </a:r>
            <a:r>
              <a:rPr lang="en-GB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men with IVF treatment (</a:t>
            </a:r>
            <a:r>
              <a:rPr lang="en-GB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=38), </a:t>
            </a:r>
            <a:r>
              <a:rPr lang="en-GB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win pregnancy (</a:t>
            </a:r>
            <a:r>
              <a:rPr lang="en-GB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=90) and </a:t>
            </a:r>
            <a:r>
              <a:rPr lang="en-GB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adjusted for maternal age, smoking, BMI, parity</a:t>
            </a:r>
            <a:r>
              <a:rPr lang="en-GB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placental weight at birth, </a:t>
            </a:r>
            <a:r>
              <a:rPr lang="en-GB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ducation level, </a:t>
            </a:r>
            <a:r>
              <a:rPr lang="en-GB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hnicity,  gestational age at birth, gestational weight gain and </a:t>
            </a:r>
            <a:r>
              <a:rPr lang="en-GB" alt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etal</a:t>
            </a:r>
            <a:r>
              <a:rPr lang="en-GB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x. </a:t>
            </a:r>
            <a:endParaRPr lang="en-US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2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703" t="7519" r="6457" b="10225"/>
          <a:stretch/>
        </p:blipFill>
        <p:spPr bwMode="auto">
          <a:xfrm>
            <a:off x="3424341" y="687361"/>
            <a:ext cx="2493706" cy="23330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3" name="TextBox 32"/>
          <p:cNvSpPr txBox="1"/>
          <p:nvPr/>
        </p:nvSpPr>
        <p:spPr>
          <a:xfrm>
            <a:off x="3424341" y="3028891"/>
            <a:ext cx="26598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-2                   0                   2                         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>
            <a:spLocks noChangeArrowheads="1"/>
          </p:cNvSpPr>
          <p:nvPr/>
        </p:nvSpPr>
        <p:spPr bwMode="auto">
          <a:xfrm>
            <a:off x="3038868" y="1104586"/>
            <a:ext cx="50392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Box 34"/>
          <p:cNvSpPr txBox="1">
            <a:spLocks noChangeArrowheads="1"/>
          </p:cNvSpPr>
          <p:nvPr/>
        </p:nvSpPr>
        <p:spPr bwMode="auto">
          <a:xfrm>
            <a:off x="3012884" y="1837462"/>
            <a:ext cx="50392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0.5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TextBox 35"/>
          <p:cNvSpPr txBox="1">
            <a:spLocks noChangeArrowheads="1"/>
          </p:cNvSpPr>
          <p:nvPr/>
        </p:nvSpPr>
        <p:spPr bwMode="auto">
          <a:xfrm>
            <a:off x="3003226" y="2553263"/>
            <a:ext cx="50392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.0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2777897" y="679522"/>
            <a:ext cx="353943" cy="224343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nl-NL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rthweight (SD)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3502818" y="3152001"/>
            <a:ext cx="2436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nl-NL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SD)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3612331" y="2676373"/>
            <a:ext cx="7048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nl-NL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&lt;0.001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0" name="Picture 3"/>
          <p:cNvPicPr>
            <a:picLocks noChangeAspect="1" noChangeArrowheads="1"/>
          </p:cNvPicPr>
          <p:nvPr/>
        </p:nvPicPr>
        <p:blipFill rotWithShape="1">
          <a:blip r:embed="rId3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30" t="7741" r="6007" b="10226"/>
          <a:stretch/>
        </p:blipFill>
        <p:spPr bwMode="auto">
          <a:xfrm>
            <a:off x="3437751" y="3429000"/>
            <a:ext cx="2502401" cy="23276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1" name="TextBox 40"/>
          <p:cNvSpPr txBox="1"/>
          <p:nvPr/>
        </p:nvSpPr>
        <p:spPr>
          <a:xfrm>
            <a:off x="3400511" y="5756017"/>
            <a:ext cx="26598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-2                    0                   2                         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3478989" y="5863738"/>
            <a:ext cx="2436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nl-NL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SD)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TextBox 42"/>
          <p:cNvSpPr txBox="1">
            <a:spLocks noChangeArrowheads="1"/>
          </p:cNvSpPr>
          <p:nvPr/>
        </p:nvSpPr>
        <p:spPr bwMode="auto">
          <a:xfrm>
            <a:off x="3048194" y="3841462"/>
            <a:ext cx="50392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3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TextBox 43"/>
          <p:cNvSpPr txBox="1">
            <a:spLocks noChangeArrowheads="1"/>
          </p:cNvSpPr>
          <p:nvPr/>
        </p:nvSpPr>
        <p:spPr bwMode="auto">
          <a:xfrm>
            <a:off x="3045709" y="4415536"/>
            <a:ext cx="50392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9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TextBox 44"/>
          <p:cNvSpPr txBox="1">
            <a:spLocks noChangeArrowheads="1"/>
          </p:cNvSpPr>
          <p:nvPr/>
        </p:nvSpPr>
        <p:spPr bwMode="auto">
          <a:xfrm>
            <a:off x="3055300" y="4989915"/>
            <a:ext cx="50392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5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2777897" y="3441741"/>
            <a:ext cx="353943" cy="226403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nl-NL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isk of SGA (p)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3549632" y="5378742"/>
            <a:ext cx="7048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nl-NL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=0.02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974461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/>
          <p:cNvSpPr txBox="1">
            <a:spLocks/>
          </p:cNvSpPr>
          <p:nvPr/>
        </p:nvSpPr>
        <p:spPr>
          <a:xfrm>
            <a:off x="0" y="0"/>
            <a:ext cx="9144000" cy="57606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nl-NL" sz="1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nl-NL" sz="18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</a:t>
            </a:r>
            <a:r>
              <a:rPr lang="nl-NL" sz="1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2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nl-NL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nl-NL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sociation</a:t>
            </a:r>
            <a:r>
              <a:rPr lang="nl-NL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nl-NL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ternal</a:t>
            </a:r>
            <a:r>
              <a:rPr lang="nl-NL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asured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the 11th or 12th week cut-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fs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nl-NL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mall </a:t>
            </a:r>
            <a:r>
              <a:rPr lang="nl-NL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nl-NL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stational</a:t>
            </a:r>
            <a:r>
              <a:rPr lang="nl-NL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ge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77736769"/>
              </p:ext>
            </p:extLst>
          </p:nvPr>
        </p:nvGraphicFramePr>
        <p:xfrm>
          <a:off x="2699792" y="836712"/>
          <a:ext cx="3096344" cy="1944219"/>
        </p:xfrm>
        <a:graphic>
          <a:graphicData uri="http://schemas.openxmlformats.org/drawingml/2006/table">
            <a:tbl>
              <a:tblPr firstRow="1" firstCol="1" bandRow="1"/>
              <a:tblGrid>
                <a:gridCol w="936104"/>
                <a:gridCol w="683618"/>
                <a:gridCol w="844754"/>
                <a:gridCol w="631868"/>
              </a:tblGrid>
              <a:tr h="330753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 err="1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hCG</a:t>
                      </a:r>
                      <a:r>
                        <a:rPr lang="en-US" sz="1200" b="1" baseline="0" dirty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200" b="1" baseline="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cut-off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OR 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(95%CI)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b="1" i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</a:t>
                      </a:r>
                      <a:r>
                        <a:rPr lang="en-US" sz="1200" b="1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value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68911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b="1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&lt;5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2.21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(1.04-4.70)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b="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0.04</a:t>
                      </a:r>
                      <a:endParaRPr lang="en-US" sz="1200" b="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68911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&lt;10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0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.09-3.67)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200" b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268911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b="1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&lt;15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0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.05-3.10)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200" b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68911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b="1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&gt;85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1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200" b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39-1.66)</a:t>
                      </a:r>
                      <a:endParaRPr 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200" b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7</a:t>
                      </a:r>
                      <a:endParaRPr lang="en-US" sz="1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268911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b="1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&gt;90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2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45-2.32)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nl-NL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6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68911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b="1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&gt;95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1.52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l-NL" sz="120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(0.58-4.01)</a:t>
                      </a:r>
                      <a:endParaRPr lang="en-US" sz="1200" dirty="0" smtClean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200" b="0" dirty="0" smtClean="0">
                          <a:effectLst/>
                          <a:latin typeface="Times New Roman" panose="02020603050405020304" pitchFamily="18" charset="0"/>
                          <a:ea typeface="Calibri"/>
                          <a:cs typeface="Times New Roman" panose="02020603050405020304" pitchFamily="18" charset="0"/>
                        </a:rPr>
                        <a:t>0.40</a:t>
                      </a:r>
                      <a:endParaRPr lang="en-US" sz="1200" b="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</a:tbl>
          </a:graphicData>
        </a:graphic>
      </p:graphicFrame>
      <p:sp>
        <p:nvSpPr>
          <p:cNvPr id="4" name="Rectangle 27"/>
          <p:cNvSpPr/>
          <p:nvPr/>
        </p:nvSpPr>
        <p:spPr>
          <a:xfrm>
            <a:off x="-27410" y="2996952"/>
            <a:ext cx="9171409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Bef>
                <a:spcPct val="0"/>
              </a:spcBef>
            </a:pP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shows the association between different cut-off levels for total </a:t>
            </a:r>
            <a:r>
              <a:rPr lang="en-US" alt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standardized to gestational age; SD) and small for </a:t>
            </a: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stational age (defined as birthweight below 10</a:t>
            </a:r>
            <a:r>
              <a:rPr lang="en-US" alt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ercentile for gestational age) as </a:t>
            </a: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dds ratio </a:t>
            </a: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95 percent confidence interval. Analyses were performed </a:t>
            </a: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ter </a:t>
            </a: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clusion of </a:t>
            </a:r>
            <a:r>
              <a:rPr lang="en-GB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men with IVF treatment (</a:t>
            </a:r>
            <a:r>
              <a:rPr lang="en-GB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=38), </a:t>
            </a:r>
            <a:r>
              <a:rPr lang="en-GB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win pregnancy (</a:t>
            </a:r>
            <a:r>
              <a:rPr lang="en-GB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=90) and </a:t>
            </a:r>
            <a:r>
              <a:rPr lang="en-GB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adjusted for maternal age, smoking, BMI, parity</a:t>
            </a:r>
            <a:r>
              <a:rPr lang="en-GB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placental weight at birth, </a:t>
            </a:r>
            <a:r>
              <a:rPr lang="en-GB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ducation level, </a:t>
            </a:r>
            <a:r>
              <a:rPr lang="en-GB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hnicity, gestational age at birth, gestational weight gain and </a:t>
            </a:r>
            <a:r>
              <a:rPr lang="en-GB" alt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etal</a:t>
            </a:r>
            <a:r>
              <a:rPr lang="en-GB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x. </a:t>
            </a:r>
            <a:endParaRPr lang="en-US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045065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89372506"/>
              </p:ext>
            </p:extLst>
          </p:nvPr>
        </p:nvGraphicFramePr>
        <p:xfrm>
          <a:off x="676275" y="847725"/>
          <a:ext cx="7429500" cy="4733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1" name="Document" r:id="rId5" imgW="11961945" imgH="7526108" progId="Word.Document.12">
                  <p:embed/>
                </p:oleObj>
              </mc:Choice>
              <mc:Fallback>
                <p:oleObj name="Document" r:id="rId5" imgW="11961945" imgH="7526108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76275" y="847725"/>
                        <a:ext cx="7429500" cy="4733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Rectangle 2"/>
          <p:cNvSpPr/>
          <p:nvPr/>
        </p:nvSpPr>
        <p:spPr>
          <a:xfrm>
            <a:off x="16346" y="2348880"/>
            <a:ext cx="9031288" cy="1015663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spcBef>
                <a:spcPct val="0"/>
              </a:spcBef>
            </a:pPr>
            <a:r>
              <a:rPr lang="en-US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alues are regression coefficients (95% confidence intervals) from the linear</a:t>
            </a:r>
            <a:r>
              <a:rPr lang="en-US" altLang="en-US" sz="10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gression models for total </a:t>
            </a:r>
            <a:r>
              <a:rPr lang="en-US" alt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en-US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standardized according to gestational age at measurement; SD) and birthweight (standardized according to gestational age at birth; </a:t>
            </a:r>
            <a:r>
              <a:rPr lang="en-US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D). Analyses </a:t>
            </a:r>
            <a:r>
              <a:rPr lang="en-US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performed after exclusion of </a:t>
            </a:r>
            <a:r>
              <a:rPr lang="en-GB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men with IVF treatment (N=38), twin </a:t>
            </a:r>
            <a:r>
              <a:rPr lang="en-GB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egnancy (N=90</a:t>
            </a:r>
            <a:r>
              <a:rPr lang="en-GB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were adjusted for maternal age, smoking, BMI, parity,  placental weight at birth, education level, ethnicity, gestational weight gain and </a:t>
            </a:r>
            <a:r>
              <a:rPr lang="en-GB" alt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etal</a:t>
            </a:r>
            <a:r>
              <a:rPr lang="en-GB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x. </a:t>
            </a:r>
            <a:r>
              <a:rPr lang="en-GB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n-linear associations are presented with the two estimates for </a:t>
            </a:r>
            <a:r>
              <a:rPr lang="en-GB" altLang="en-U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en-GB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altLang="en-U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d</a:t>
            </a:r>
            <a:r>
              <a:rPr lang="en-GB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 and the </a:t>
            </a:r>
            <a:r>
              <a:rPr lang="en-GB" altLang="en-US" sz="10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ut-off was based </a:t>
            </a:r>
            <a:r>
              <a:rPr lang="en-GB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 the shape of the association.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defRPr/>
            </a:pPr>
            <a:r>
              <a:rPr lang="en-US" sz="1000" dirty="0" smtClean="0"/>
              <a:t>* </a:t>
            </a:r>
            <a:r>
              <a:rPr lang="en-US" altLang="en-US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&lt;0.05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defRPr/>
            </a:pPr>
            <a:r>
              <a:rPr lang="en-US" sz="1000" dirty="0" smtClean="0"/>
              <a:t>**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&lt;0.001</a:t>
            </a:r>
            <a:endParaRPr lang="en-US" altLang="en-US" sz="1000" i="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47001045"/>
      </p:ext>
    </p:extLst>
  </p:cSld>
  <p:clrMapOvr>
    <a:masterClrMapping/>
  </p:clrMapOvr>
  <p:transition spd="slow" advTm="56751"/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 txBox="1">
            <a:spLocks/>
          </p:cNvSpPr>
          <p:nvPr/>
        </p:nvSpPr>
        <p:spPr>
          <a:xfrm>
            <a:off x="0" y="0"/>
            <a:ext cx="9144000" cy="576064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2500" lnSpcReduction="100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nl-NL" sz="1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nl-NL" sz="18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nl-NL" sz="1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4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The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sociation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ternal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nl-NL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rown-rump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ngth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in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bgroup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omen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liable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ycle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nown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last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nstrual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eriode (N=1526).</a:t>
            </a:r>
            <a:endParaRPr 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>
            <a:spLocks noChangeArrowheads="1"/>
          </p:cNvSpPr>
          <p:nvPr/>
        </p:nvSpPr>
        <p:spPr bwMode="auto">
          <a:xfrm>
            <a:off x="2518711" y="2816455"/>
            <a:ext cx="49728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  <a:endParaRPr lang="en-US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>
            <a:spLocks noChangeArrowheads="1"/>
          </p:cNvSpPr>
          <p:nvPr/>
        </p:nvSpPr>
        <p:spPr bwMode="auto">
          <a:xfrm>
            <a:off x="2554715" y="3499378"/>
            <a:ext cx="42527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0.2</a:t>
            </a:r>
            <a:endParaRPr lang="en-US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2299682" y="1357141"/>
            <a:ext cx="400110" cy="266572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nl-NL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RL (SD)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979988" y="4293096"/>
            <a:ext cx="27698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nl-NL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SD) 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-10862" y="6257836"/>
            <a:ext cx="9050380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Bef>
                <a:spcPct val="0"/>
              </a:spcBef>
            </a:pP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ot shows </a:t>
            </a: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near regression model for total </a:t>
            </a:r>
            <a:r>
              <a:rPr lang="en-US" alt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SD</a:t>
            </a: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crown-rump length </a:t>
            </a: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djusted according to week of gestation; available in </a:t>
            </a:r>
            <a:r>
              <a:rPr lang="nl-NL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=1526</a:t>
            </a: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SD) as </a:t>
            </a: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dicted mean with 95 percent confidence interval. Analyses were performed </a:t>
            </a: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ter </a:t>
            </a: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clusion of </a:t>
            </a:r>
            <a:r>
              <a:rPr lang="en-GB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men with IVF treatment (</a:t>
            </a:r>
            <a:r>
              <a:rPr lang="en-GB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=38), </a:t>
            </a:r>
            <a:r>
              <a:rPr lang="en-GB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win pregnancy (</a:t>
            </a:r>
            <a:r>
              <a:rPr lang="en-GB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=90) and </a:t>
            </a:r>
            <a:r>
              <a:rPr lang="en-GB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adjusted for maternal age, smoking, BMI, parity, education level, </a:t>
            </a:r>
            <a:r>
              <a:rPr lang="en-GB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hnicity, gestational weight gain and </a:t>
            </a:r>
            <a:r>
              <a:rPr lang="en-GB" alt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etal</a:t>
            </a:r>
            <a:r>
              <a:rPr lang="en-GB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x. </a:t>
            </a:r>
            <a:endParaRPr lang="en-US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TextBox 40"/>
          <p:cNvSpPr txBox="1">
            <a:spLocks noChangeArrowheads="1"/>
          </p:cNvSpPr>
          <p:nvPr/>
        </p:nvSpPr>
        <p:spPr bwMode="auto">
          <a:xfrm>
            <a:off x="2535410" y="2150431"/>
            <a:ext cx="48521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endParaRPr lang="en-US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TextBox 41"/>
          <p:cNvSpPr txBox="1">
            <a:spLocks noChangeArrowheads="1"/>
          </p:cNvSpPr>
          <p:nvPr/>
        </p:nvSpPr>
        <p:spPr bwMode="auto">
          <a:xfrm>
            <a:off x="2545442" y="1476109"/>
            <a:ext cx="4852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  <a:endParaRPr lang="en-US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2917121" y="4022865"/>
            <a:ext cx="29510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-</a:t>
            </a:r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       -2        -1         0         1         2         3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938" t="9280" r="7166" b="10080"/>
          <a:stretch/>
        </p:blipFill>
        <p:spPr bwMode="auto">
          <a:xfrm>
            <a:off x="2917121" y="1397202"/>
            <a:ext cx="2832751" cy="26615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3" name="TextBox 22"/>
          <p:cNvSpPr txBox="1"/>
          <p:nvPr/>
        </p:nvSpPr>
        <p:spPr>
          <a:xfrm>
            <a:off x="3110225" y="3676794"/>
            <a:ext cx="10130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nl-NL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=0.13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361459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TextBox 80"/>
          <p:cNvSpPr txBox="1"/>
          <p:nvPr/>
        </p:nvSpPr>
        <p:spPr>
          <a:xfrm>
            <a:off x="0" y="456605"/>
            <a:ext cx="9144000" cy="276999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nl-NL" sz="1200" b="1" u="sng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mongst</a:t>
            </a:r>
            <a:r>
              <a:rPr lang="nl-NL" sz="1200" b="1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ale </a:t>
            </a:r>
            <a:r>
              <a:rPr lang="nl-NL" sz="1200" b="1" u="sng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etuses</a:t>
            </a:r>
            <a:endParaRPr lang="en-US" sz="1200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320005" y="2924944"/>
            <a:ext cx="23527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       -2          -1          0           1           2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1667" y="2446818"/>
            <a:ext cx="45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.0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1667" y="2072150"/>
            <a:ext cx="45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0.5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82410" y="1700808"/>
            <a:ext cx="45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16194" y="2677650"/>
            <a:ext cx="9001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&lt;0.05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2770775" y="2670661"/>
            <a:ext cx="9001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=0.04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5093999" y="2646993"/>
            <a:ext cx="9001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=0.08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itle 1"/>
          <p:cNvSpPr txBox="1">
            <a:spLocks/>
          </p:cNvSpPr>
          <p:nvPr/>
        </p:nvSpPr>
        <p:spPr>
          <a:xfrm>
            <a:off x="-25110" y="-16789"/>
            <a:ext cx="9144000" cy="57606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nl-NL" sz="1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nl-NL" sz="18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nl-NL" sz="1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The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sociation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ternal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er week of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asurement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rth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ight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atified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etal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x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34352" y="692696"/>
            <a:ext cx="19492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200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th week</a:t>
            </a:r>
            <a:endParaRPr lang="en-US" sz="1200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2631341" y="692696"/>
            <a:ext cx="18685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200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2th week</a:t>
            </a:r>
            <a:endParaRPr lang="en-US" sz="1200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5004048" y="692696"/>
            <a:ext cx="18766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200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3th week</a:t>
            </a:r>
            <a:endParaRPr lang="en-US" sz="1200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-108520" y="882528"/>
            <a:ext cx="338554" cy="198853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nl-NL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rthweight (SD)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2157899" y="842296"/>
            <a:ext cx="338554" cy="203241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nl-NL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rthweight (SD)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4499992" y="836712"/>
            <a:ext cx="338554" cy="198853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nl-NL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rthweight (SD)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323528" y="3095203"/>
            <a:ext cx="2160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nl-NL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SD)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2641175" y="3095204"/>
            <a:ext cx="2160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nl-NL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SD)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4975551" y="3095204"/>
            <a:ext cx="2160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nl-NL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SD)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467544" y="5445640"/>
            <a:ext cx="5040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=0.1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323768" y="5903694"/>
            <a:ext cx="2160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nl-NL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SD)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Rectangle 79"/>
          <p:cNvSpPr/>
          <p:nvPr/>
        </p:nvSpPr>
        <p:spPr>
          <a:xfrm>
            <a:off x="-4659" y="6085694"/>
            <a:ext cx="9050380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Bef>
                <a:spcPct val="0"/>
              </a:spcBef>
            </a:pP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ots show the </a:t>
            </a: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gistic and linear regression models for </a:t>
            </a: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</a:t>
            </a:r>
            <a:r>
              <a:rPr lang="en-US" alt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standardized according to gestational age at measurement; SD) and </a:t>
            </a:r>
            <a:r>
              <a:rPr lang="en-US" altLang="en-US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rthweight</a:t>
            </a: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(standardized according to gestational age at birth; SD) or small for gestational age (defined as </a:t>
            </a:r>
            <a:r>
              <a:rPr lang="en-US" altLang="en-US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rthweight</a:t>
            </a: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elow 10</a:t>
            </a:r>
            <a:r>
              <a:rPr lang="en-US" altLang="en-US" sz="11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ercentile for gestational age) as </a:t>
            </a: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dicted mean with 95 percent confidence interval. Analyses were performed </a:t>
            </a: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ter </a:t>
            </a: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clusion of </a:t>
            </a:r>
            <a:r>
              <a:rPr lang="en-GB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men with IVF treatment (</a:t>
            </a:r>
            <a:r>
              <a:rPr lang="en-GB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=38), </a:t>
            </a:r>
            <a:r>
              <a:rPr lang="en-GB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win pregnancy (</a:t>
            </a:r>
            <a:r>
              <a:rPr lang="en-GB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=90) and </a:t>
            </a:r>
            <a:r>
              <a:rPr lang="en-GB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adjusted for maternal age, smoking, BMI, parity, </a:t>
            </a:r>
            <a:r>
              <a:rPr lang="en-GB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cental weight at birth, education </a:t>
            </a:r>
            <a:r>
              <a:rPr lang="en-GB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vel, </a:t>
            </a:r>
            <a:r>
              <a:rPr lang="en-GB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hnicity and gestational weight gain.</a:t>
            </a:r>
            <a:endParaRPr lang="en-US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350424" y="863134"/>
            <a:ext cx="19642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N=120)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2627784" y="863134"/>
            <a:ext cx="18988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N=400)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5009546" y="863134"/>
            <a:ext cx="18766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N=720)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82410" y="1340768"/>
            <a:ext cx="45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5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2314658" y="2492896"/>
            <a:ext cx="45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.0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2314658" y="1988840"/>
            <a:ext cx="45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0.5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2339752" y="1541984"/>
            <a:ext cx="45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2339752" y="1052736"/>
            <a:ext cx="45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5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2507261" y="2924944"/>
            <a:ext cx="235277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-3        -2        -1          0          1         2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4644008" y="2492896"/>
            <a:ext cx="45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.0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4661077" y="2005420"/>
            <a:ext cx="45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0.5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4694535" y="1541984"/>
            <a:ext cx="45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4692279" y="1052736"/>
            <a:ext cx="45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5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4960640" y="2929124"/>
            <a:ext cx="19427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-3       -2        -1       </a:t>
            </a:r>
            <a:r>
              <a:rPr lang="nl-NL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0         1         2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7271696" y="2637550"/>
            <a:ext cx="10702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=0.19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7093703" y="2924944"/>
            <a:ext cx="19427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-3        -2       -1         0          1         2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6726461" y="836712"/>
            <a:ext cx="338554" cy="198853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nl-NL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rthweight (SD)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6896156" y="1304071"/>
            <a:ext cx="45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5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6905471" y="1670456"/>
            <a:ext cx="45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6886236" y="2056880"/>
            <a:ext cx="45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0.5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6878050" y="2420888"/>
            <a:ext cx="45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.0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7092520" y="3095202"/>
            <a:ext cx="2160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nl-NL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SD)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9" name="TextBox 108"/>
          <p:cNvSpPr txBox="1"/>
          <p:nvPr/>
        </p:nvSpPr>
        <p:spPr>
          <a:xfrm>
            <a:off x="7165062" y="703729"/>
            <a:ext cx="18714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200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4th week</a:t>
            </a:r>
            <a:endParaRPr lang="en-US" sz="1200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262923" y="5703059"/>
            <a:ext cx="20207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-</a:t>
            </a:r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      -2       -1         0         1        2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-108520" y="3744718"/>
            <a:ext cx="338554" cy="198853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nl-NL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rthweight (SD)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35496" y="4941168"/>
            <a:ext cx="45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.0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35496" y="4653136"/>
            <a:ext cx="45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0.5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" name="TextBox 115"/>
          <p:cNvSpPr txBox="1"/>
          <p:nvPr/>
        </p:nvSpPr>
        <p:spPr>
          <a:xfrm>
            <a:off x="82410" y="4350296"/>
            <a:ext cx="45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" name="TextBox 116"/>
          <p:cNvSpPr txBox="1"/>
          <p:nvPr/>
        </p:nvSpPr>
        <p:spPr>
          <a:xfrm>
            <a:off x="82410" y="4005064"/>
            <a:ext cx="45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5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35496" y="5247153"/>
            <a:ext cx="45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.5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9" name="Picture 4"/>
          <p:cNvPicPr>
            <a:picLocks noChangeAspect="1" noChangeArrowheads="1"/>
          </p:cNvPicPr>
          <p:nvPr/>
        </p:nvPicPr>
        <p:blipFill rotWithShape="1">
          <a:blip r:embed="rId2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61" t="7404" r="5730" b="9781"/>
          <a:stretch/>
        </p:blipFill>
        <p:spPr bwMode="auto">
          <a:xfrm>
            <a:off x="356622" y="3853252"/>
            <a:ext cx="1927008" cy="18800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0" name="TextBox 119"/>
          <p:cNvSpPr txBox="1"/>
          <p:nvPr/>
        </p:nvSpPr>
        <p:spPr>
          <a:xfrm>
            <a:off x="2683906" y="5440031"/>
            <a:ext cx="66395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=0.08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1" name="TextBox 120"/>
          <p:cNvSpPr txBox="1"/>
          <p:nvPr/>
        </p:nvSpPr>
        <p:spPr>
          <a:xfrm>
            <a:off x="2623301" y="5703059"/>
            <a:ext cx="20207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-</a:t>
            </a:r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      -2      -1        0        1        2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2201833" y="3739109"/>
            <a:ext cx="338554" cy="198853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nl-NL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rthweight (SD)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3" name="TextBox 122"/>
          <p:cNvSpPr txBox="1"/>
          <p:nvPr/>
        </p:nvSpPr>
        <p:spPr>
          <a:xfrm>
            <a:off x="2339752" y="5013176"/>
            <a:ext cx="45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.0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2339752" y="4647527"/>
            <a:ext cx="45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0.5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5" name="TextBox 124"/>
          <p:cNvSpPr txBox="1"/>
          <p:nvPr/>
        </p:nvSpPr>
        <p:spPr>
          <a:xfrm>
            <a:off x="2386666" y="4278288"/>
            <a:ext cx="45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2386666" y="3861048"/>
            <a:ext cx="45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5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2339752" y="5430416"/>
            <a:ext cx="45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.5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9" name="TextBox 128"/>
          <p:cNvSpPr txBox="1"/>
          <p:nvPr/>
        </p:nvSpPr>
        <p:spPr>
          <a:xfrm>
            <a:off x="5060170" y="5417954"/>
            <a:ext cx="5919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=0.57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0" name="TextBox 129"/>
          <p:cNvSpPr txBox="1"/>
          <p:nvPr/>
        </p:nvSpPr>
        <p:spPr>
          <a:xfrm>
            <a:off x="4999566" y="5703059"/>
            <a:ext cx="19753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      -2       -1        0        1        2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4484106" y="3717032"/>
            <a:ext cx="338554" cy="198853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nl-NL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rthweight (SD)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2" name="TextBox 131"/>
          <p:cNvSpPr txBox="1"/>
          <p:nvPr/>
        </p:nvSpPr>
        <p:spPr>
          <a:xfrm>
            <a:off x="4628122" y="5013176"/>
            <a:ext cx="45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.0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3" name="TextBox 132"/>
          <p:cNvSpPr txBox="1"/>
          <p:nvPr/>
        </p:nvSpPr>
        <p:spPr>
          <a:xfrm>
            <a:off x="4628122" y="4625450"/>
            <a:ext cx="45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0.5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4675036" y="4221088"/>
            <a:ext cx="45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5" name="TextBox 134"/>
          <p:cNvSpPr txBox="1"/>
          <p:nvPr/>
        </p:nvSpPr>
        <p:spPr>
          <a:xfrm>
            <a:off x="4675036" y="3846240"/>
            <a:ext cx="45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5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6" name="TextBox 135"/>
          <p:cNvSpPr txBox="1"/>
          <p:nvPr/>
        </p:nvSpPr>
        <p:spPr>
          <a:xfrm>
            <a:off x="4628122" y="5430416"/>
            <a:ext cx="45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.5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8" name="TextBox 137"/>
          <p:cNvSpPr txBox="1"/>
          <p:nvPr/>
        </p:nvSpPr>
        <p:spPr>
          <a:xfrm>
            <a:off x="7286818" y="5430416"/>
            <a:ext cx="6480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=0.88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9" name="TextBox 138"/>
          <p:cNvSpPr txBox="1"/>
          <p:nvPr/>
        </p:nvSpPr>
        <p:spPr>
          <a:xfrm>
            <a:off x="7210327" y="5703059"/>
            <a:ext cx="18150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-</a:t>
            </a:r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     -2      -1        0       1        2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0" name="TextBox 139"/>
          <p:cNvSpPr txBox="1"/>
          <p:nvPr/>
        </p:nvSpPr>
        <p:spPr>
          <a:xfrm>
            <a:off x="6732240" y="3645024"/>
            <a:ext cx="338554" cy="198853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nl-NL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rthweight (SD)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1" name="TextBox 140"/>
          <p:cNvSpPr txBox="1"/>
          <p:nvPr/>
        </p:nvSpPr>
        <p:spPr>
          <a:xfrm>
            <a:off x="6854770" y="5036201"/>
            <a:ext cx="45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.0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2" name="TextBox 141"/>
          <p:cNvSpPr txBox="1"/>
          <p:nvPr/>
        </p:nvSpPr>
        <p:spPr>
          <a:xfrm>
            <a:off x="6881437" y="4638328"/>
            <a:ext cx="45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0.5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3" name="TextBox 142"/>
          <p:cNvSpPr txBox="1"/>
          <p:nvPr/>
        </p:nvSpPr>
        <p:spPr>
          <a:xfrm>
            <a:off x="6926231" y="4242435"/>
            <a:ext cx="45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4" name="TextBox 143"/>
          <p:cNvSpPr txBox="1"/>
          <p:nvPr/>
        </p:nvSpPr>
        <p:spPr>
          <a:xfrm>
            <a:off x="6904478" y="3861048"/>
            <a:ext cx="45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5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5" name="TextBox 144"/>
          <p:cNvSpPr txBox="1"/>
          <p:nvPr/>
        </p:nvSpPr>
        <p:spPr>
          <a:xfrm>
            <a:off x="6854770" y="5430416"/>
            <a:ext cx="4571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.5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50" name="Picture 5"/>
          <p:cNvPicPr>
            <a:picLocks noChangeAspect="1" noChangeArrowheads="1"/>
          </p:cNvPicPr>
          <p:nvPr/>
        </p:nvPicPr>
        <p:blipFill rotWithShape="1">
          <a:blip r:embed="rId3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09" t="8000" r="5730" b="10119"/>
          <a:stretch/>
        </p:blipFill>
        <p:spPr bwMode="auto">
          <a:xfrm>
            <a:off x="2627784" y="3861048"/>
            <a:ext cx="1928004" cy="187220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4" name="Picture 6"/>
          <p:cNvPicPr>
            <a:picLocks noChangeAspect="1" noChangeArrowheads="1"/>
          </p:cNvPicPr>
          <p:nvPr/>
        </p:nvPicPr>
        <p:blipFill rotWithShape="1">
          <a:blip r:embed="rId4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52" t="8272" r="6440" b="10449"/>
          <a:stretch/>
        </p:blipFill>
        <p:spPr bwMode="auto">
          <a:xfrm>
            <a:off x="4949542" y="3823056"/>
            <a:ext cx="1926714" cy="19147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5" name="Picture 7"/>
          <p:cNvPicPr>
            <a:picLocks noChangeAspect="1" noChangeArrowheads="1"/>
          </p:cNvPicPr>
          <p:nvPr/>
        </p:nvPicPr>
        <p:blipFill rotWithShape="1">
          <a:blip r:embed="rId5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86" t="8825" r="6610" b="10604"/>
          <a:stretch/>
        </p:blipFill>
        <p:spPr bwMode="auto">
          <a:xfrm>
            <a:off x="7181858" y="3861048"/>
            <a:ext cx="1833152" cy="18767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51" name="Picture 2"/>
          <p:cNvPicPr>
            <a:picLocks noChangeAspect="1" noChangeArrowheads="1"/>
          </p:cNvPicPr>
          <p:nvPr/>
        </p:nvPicPr>
        <p:blipFill rotWithShape="1">
          <a:blip r:embed="rId6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658" t="8953" r="6395" b="9530"/>
          <a:stretch/>
        </p:blipFill>
        <p:spPr bwMode="auto">
          <a:xfrm>
            <a:off x="349129" y="1168152"/>
            <a:ext cx="1934501" cy="18043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52" name="Picture 3"/>
          <p:cNvPicPr>
            <a:picLocks noChangeAspect="1" noChangeArrowheads="1"/>
          </p:cNvPicPr>
          <p:nvPr/>
        </p:nvPicPr>
        <p:blipFill rotWithShape="1">
          <a:blip r:embed="rId7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545" t="8412" r="6209" b="10215"/>
          <a:stretch/>
        </p:blipFill>
        <p:spPr bwMode="auto">
          <a:xfrm>
            <a:off x="2592161" y="1124744"/>
            <a:ext cx="1934500" cy="182878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53" name="Picture 4"/>
          <p:cNvPicPr>
            <a:picLocks noChangeAspect="1" noChangeArrowheads="1"/>
          </p:cNvPicPr>
          <p:nvPr/>
        </p:nvPicPr>
        <p:blipFill rotWithShape="1">
          <a:blip r:embed="rId8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546" t="9279" r="5657" b="9634"/>
          <a:stretch/>
        </p:blipFill>
        <p:spPr bwMode="auto">
          <a:xfrm>
            <a:off x="4947762" y="1145381"/>
            <a:ext cx="1930288" cy="18193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54" name="Picture 3"/>
          <p:cNvPicPr>
            <a:picLocks noChangeAspect="1" noChangeArrowheads="1"/>
          </p:cNvPicPr>
          <p:nvPr/>
        </p:nvPicPr>
        <p:blipFill rotWithShape="1">
          <a:blip r:embed="rId9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59" t="7690" r="6086" b="10175"/>
          <a:stretch/>
        </p:blipFill>
        <p:spPr bwMode="auto">
          <a:xfrm>
            <a:off x="7162494" y="1059669"/>
            <a:ext cx="1873468" cy="19088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5" name="TextBox 154"/>
          <p:cNvSpPr txBox="1"/>
          <p:nvPr/>
        </p:nvSpPr>
        <p:spPr>
          <a:xfrm>
            <a:off x="2484008" y="5919083"/>
            <a:ext cx="2160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nl-NL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SD)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6" name="TextBox 155"/>
          <p:cNvSpPr txBox="1"/>
          <p:nvPr/>
        </p:nvSpPr>
        <p:spPr>
          <a:xfrm>
            <a:off x="4860272" y="5919083"/>
            <a:ext cx="2160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nl-NL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SD)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7" name="TextBox 156"/>
          <p:cNvSpPr txBox="1"/>
          <p:nvPr/>
        </p:nvSpPr>
        <p:spPr>
          <a:xfrm>
            <a:off x="7164528" y="5919083"/>
            <a:ext cx="2160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nl-NL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SD)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416194" y="3682509"/>
            <a:ext cx="186743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N=134)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2683906" y="3669995"/>
            <a:ext cx="18718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N=383)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4975551" y="3669995"/>
            <a:ext cx="19007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N=692)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7203502" y="863134"/>
            <a:ext cx="184221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N=514)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8" name="TextBox 127"/>
          <p:cNvSpPr txBox="1"/>
          <p:nvPr/>
        </p:nvSpPr>
        <p:spPr>
          <a:xfrm>
            <a:off x="7303821" y="3702224"/>
            <a:ext cx="181506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N=546)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7" name="TextBox 80"/>
          <p:cNvSpPr txBox="1"/>
          <p:nvPr/>
        </p:nvSpPr>
        <p:spPr>
          <a:xfrm>
            <a:off x="-25110" y="3284984"/>
            <a:ext cx="9169110" cy="276999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nl-NL" sz="1200" b="1" u="sng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mongst</a:t>
            </a:r>
            <a:r>
              <a:rPr lang="nl-NL" sz="1200" b="1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200" b="1" u="sng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emale</a:t>
            </a:r>
            <a:r>
              <a:rPr lang="nl-NL" sz="1200" b="1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200" b="1" u="sng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etuses</a:t>
            </a:r>
            <a:endParaRPr lang="en-US" sz="1200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6" name="TextBox 17"/>
          <p:cNvSpPr txBox="1"/>
          <p:nvPr/>
        </p:nvSpPr>
        <p:spPr>
          <a:xfrm>
            <a:off x="323528" y="3501008"/>
            <a:ext cx="19492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200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th week</a:t>
            </a:r>
            <a:endParaRPr lang="en-US" sz="1200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7" name="TextBox 36"/>
          <p:cNvSpPr txBox="1"/>
          <p:nvPr/>
        </p:nvSpPr>
        <p:spPr>
          <a:xfrm>
            <a:off x="2620517" y="3501008"/>
            <a:ext cx="18685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200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2th week</a:t>
            </a:r>
            <a:endParaRPr lang="en-US" sz="1200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8" name="TextBox 37"/>
          <p:cNvSpPr txBox="1"/>
          <p:nvPr/>
        </p:nvSpPr>
        <p:spPr>
          <a:xfrm>
            <a:off x="4993224" y="3501008"/>
            <a:ext cx="18766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200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3th week</a:t>
            </a:r>
            <a:endParaRPr lang="en-US" sz="1200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9" name="TextBox 108"/>
          <p:cNvSpPr txBox="1"/>
          <p:nvPr/>
        </p:nvSpPr>
        <p:spPr>
          <a:xfrm>
            <a:off x="7303821" y="3512041"/>
            <a:ext cx="18714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200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4th week</a:t>
            </a:r>
            <a:endParaRPr lang="en-US" sz="1200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49115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/>
          <p:cNvPicPr>
            <a:picLocks noChangeAspect="1" noChangeArrowheads="1"/>
          </p:cNvPicPr>
          <p:nvPr/>
        </p:nvPicPr>
        <p:blipFill rotWithShape="1">
          <a:blip r:embed="rId2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51" t="8420" r="8674" b="9221"/>
          <a:stretch/>
        </p:blipFill>
        <p:spPr bwMode="auto">
          <a:xfrm>
            <a:off x="5346780" y="3501007"/>
            <a:ext cx="2400017" cy="2325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 rotWithShape="1">
          <a:blip r:embed="rId3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86" t="7563" r="6212" b="9732"/>
          <a:stretch/>
        </p:blipFill>
        <p:spPr bwMode="auto">
          <a:xfrm>
            <a:off x="1125588" y="3457995"/>
            <a:ext cx="2510307" cy="23472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7" name="Picture 5"/>
          <p:cNvPicPr>
            <a:picLocks noChangeAspect="1" noChangeArrowheads="1"/>
          </p:cNvPicPr>
          <p:nvPr/>
        </p:nvPicPr>
        <p:blipFill rotWithShape="1">
          <a:blip r:embed="rId4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63" t="7586" r="6349" b="10674"/>
          <a:stretch/>
        </p:blipFill>
        <p:spPr bwMode="auto">
          <a:xfrm>
            <a:off x="5302053" y="768505"/>
            <a:ext cx="2510307" cy="230924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1192093" y="3079280"/>
            <a:ext cx="26598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-3         -2        -1          0         1          2              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>
            <a:spLocks noChangeArrowheads="1"/>
          </p:cNvSpPr>
          <p:nvPr/>
        </p:nvSpPr>
        <p:spPr bwMode="auto">
          <a:xfrm>
            <a:off x="788632" y="1186248"/>
            <a:ext cx="50392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>
            <a:spLocks noChangeArrowheads="1"/>
          </p:cNvSpPr>
          <p:nvPr/>
        </p:nvSpPr>
        <p:spPr bwMode="auto">
          <a:xfrm>
            <a:off x="758599" y="1750138"/>
            <a:ext cx="50392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0.5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>
            <a:spLocks noChangeArrowheads="1"/>
          </p:cNvSpPr>
          <p:nvPr/>
        </p:nvSpPr>
        <p:spPr bwMode="auto">
          <a:xfrm>
            <a:off x="745587" y="2338376"/>
            <a:ext cx="50392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.0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539552" y="729911"/>
            <a:ext cx="353943" cy="224343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nl-NL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rthweight (SD)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266101" y="3213505"/>
            <a:ext cx="2436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nl-NL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SD)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375614" y="2726762"/>
            <a:ext cx="7048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nl-NL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=0.005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itle 1"/>
          <p:cNvSpPr txBox="1">
            <a:spLocks/>
          </p:cNvSpPr>
          <p:nvPr/>
        </p:nvSpPr>
        <p:spPr>
          <a:xfrm>
            <a:off x="0" y="0"/>
            <a:ext cx="9144000" cy="57606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nl-NL" sz="1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nl-NL" sz="18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nl-NL" sz="1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6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The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sociation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ternal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asured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the 11th or 12th week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rth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ight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atified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etal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x</a:t>
            </a:r>
            <a:r>
              <a:rPr lang="nl-NL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154293" y="5775067"/>
            <a:ext cx="26598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-3        -2         -1          0         1          2                         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173312" y="5898177"/>
            <a:ext cx="2436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nl-NL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SD)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>
            <a:spLocks noChangeArrowheads="1"/>
          </p:cNvSpPr>
          <p:nvPr/>
        </p:nvSpPr>
        <p:spPr bwMode="auto">
          <a:xfrm>
            <a:off x="766963" y="4293094"/>
            <a:ext cx="50392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3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>
            <a:spLocks noChangeArrowheads="1"/>
          </p:cNvSpPr>
          <p:nvPr/>
        </p:nvSpPr>
        <p:spPr bwMode="auto">
          <a:xfrm>
            <a:off x="745586" y="4622939"/>
            <a:ext cx="50392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9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>
            <a:spLocks noChangeArrowheads="1"/>
          </p:cNvSpPr>
          <p:nvPr/>
        </p:nvSpPr>
        <p:spPr bwMode="auto">
          <a:xfrm>
            <a:off x="755576" y="4941168"/>
            <a:ext cx="50392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5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539552" y="3444689"/>
            <a:ext cx="353943" cy="226403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nl-NL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isk of SGA (p)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1336744" y="5415027"/>
            <a:ext cx="7048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nl-NL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=0.08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/>
          <p:cNvSpPr txBox="1">
            <a:spLocks noChangeArrowheads="1"/>
          </p:cNvSpPr>
          <p:nvPr/>
        </p:nvSpPr>
        <p:spPr bwMode="auto">
          <a:xfrm>
            <a:off x="4932173" y="1176594"/>
            <a:ext cx="50392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>
            <a:spLocks noChangeArrowheads="1"/>
          </p:cNvSpPr>
          <p:nvPr/>
        </p:nvSpPr>
        <p:spPr bwMode="auto">
          <a:xfrm>
            <a:off x="4932173" y="1762312"/>
            <a:ext cx="50392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0.5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Box 34"/>
          <p:cNvSpPr txBox="1">
            <a:spLocks noChangeArrowheads="1"/>
          </p:cNvSpPr>
          <p:nvPr/>
        </p:nvSpPr>
        <p:spPr bwMode="auto">
          <a:xfrm>
            <a:off x="4932173" y="2338376"/>
            <a:ext cx="50392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.0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4776531" y="751530"/>
            <a:ext cx="353943" cy="224343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nl-NL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rthweight (SD)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5375026" y="3224009"/>
            <a:ext cx="2436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nl-NL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SD)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5484539" y="2698416"/>
            <a:ext cx="7048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nl-NL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=0.005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5375026" y="5888305"/>
            <a:ext cx="2436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nl-NL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SD)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4794121" y="3466308"/>
            <a:ext cx="353943" cy="226403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nl-NL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isk of SGA (p)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5445669" y="5403309"/>
            <a:ext cx="7048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nl-NL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=0.27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5375026" y="538176"/>
            <a:ext cx="23717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200" b="1" u="sng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mongst</a:t>
            </a:r>
            <a:r>
              <a:rPr lang="nl-NL" sz="1200" b="1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200" b="1" u="sng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emale</a:t>
            </a:r>
            <a:r>
              <a:rPr lang="nl-NL" sz="1200" b="1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l-NL" sz="1200" b="1" u="sng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etuses</a:t>
            </a:r>
            <a:endParaRPr lang="en-US" sz="1200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0" name="Picture 2"/>
          <p:cNvPicPr>
            <a:picLocks noChangeAspect="1" noChangeArrowheads="1"/>
          </p:cNvPicPr>
          <p:nvPr/>
        </p:nvPicPr>
        <p:blipFill rotWithShape="1">
          <a:blip r:embed="rId5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138" t="7782" r="6349" b="9873"/>
          <a:stretch/>
        </p:blipFill>
        <p:spPr bwMode="auto">
          <a:xfrm>
            <a:off x="1125588" y="768505"/>
            <a:ext cx="2510307" cy="233672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3" name="TextBox 52"/>
          <p:cNvSpPr txBox="1">
            <a:spLocks noChangeArrowheads="1"/>
          </p:cNvSpPr>
          <p:nvPr/>
        </p:nvSpPr>
        <p:spPr bwMode="auto">
          <a:xfrm>
            <a:off x="804543" y="3974867"/>
            <a:ext cx="40599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0.5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5220072" y="3058456"/>
            <a:ext cx="26598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-3         -2        -1          0         1          2              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5343003" y="5775067"/>
            <a:ext cx="26598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-3        -2       -1         0         1          2                         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TextBox 56"/>
          <p:cNvSpPr txBox="1">
            <a:spLocks noChangeArrowheads="1"/>
          </p:cNvSpPr>
          <p:nvPr/>
        </p:nvSpPr>
        <p:spPr bwMode="auto">
          <a:xfrm>
            <a:off x="5030106" y="3974867"/>
            <a:ext cx="40599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5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TextBox 57"/>
          <p:cNvSpPr txBox="1">
            <a:spLocks noChangeArrowheads="1"/>
          </p:cNvSpPr>
          <p:nvPr/>
        </p:nvSpPr>
        <p:spPr bwMode="auto">
          <a:xfrm>
            <a:off x="4973981" y="4312520"/>
            <a:ext cx="50392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3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TextBox 58"/>
          <p:cNvSpPr txBox="1">
            <a:spLocks noChangeArrowheads="1"/>
          </p:cNvSpPr>
          <p:nvPr/>
        </p:nvSpPr>
        <p:spPr bwMode="auto">
          <a:xfrm>
            <a:off x="4968110" y="4653136"/>
            <a:ext cx="50392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9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TextBox 59"/>
          <p:cNvSpPr txBox="1">
            <a:spLocks noChangeArrowheads="1"/>
          </p:cNvSpPr>
          <p:nvPr/>
        </p:nvSpPr>
        <p:spPr bwMode="auto">
          <a:xfrm>
            <a:off x="4968110" y="4982979"/>
            <a:ext cx="50392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5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TextBox 61"/>
          <p:cNvSpPr txBox="1">
            <a:spLocks noChangeArrowheads="1"/>
          </p:cNvSpPr>
          <p:nvPr/>
        </p:nvSpPr>
        <p:spPr bwMode="auto">
          <a:xfrm>
            <a:off x="4965360" y="5301208"/>
            <a:ext cx="50392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2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TextBox 42"/>
          <p:cNvSpPr txBox="1">
            <a:spLocks noChangeArrowheads="1"/>
          </p:cNvSpPr>
          <p:nvPr/>
        </p:nvSpPr>
        <p:spPr bwMode="auto">
          <a:xfrm>
            <a:off x="815929" y="3645024"/>
            <a:ext cx="40599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7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TextBox 43"/>
          <p:cNvSpPr txBox="1">
            <a:spLocks noChangeArrowheads="1"/>
          </p:cNvSpPr>
          <p:nvPr/>
        </p:nvSpPr>
        <p:spPr bwMode="auto">
          <a:xfrm>
            <a:off x="755576" y="5280198"/>
            <a:ext cx="50392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2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TextBox 48"/>
          <p:cNvSpPr txBox="1">
            <a:spLocks noChangeArrowheads="1"/>
          </p:cNvSpPr>
          <p:nvPr/>
        </p:nvSpPr>
        <p:spPr bwMode="auto">
          <a:xfrm>
            <a:off x="5020911" y="3645024"/>
            <a:ext cx="40599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nl-NL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0.7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TextBox 47"/>
          <p:cNvSpPr txBox="1"/>
          <p:nvPr/>
        </p:nvSpPr>
        <p:spPr>
          <a:xfrm>
            <a:off x="1187624" y="538176"/>
            <a:ext cx="23717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200" b="1" u="sng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mongst</a:t>
            </a:r>
            <a:r>
              <a:rPr lang="nl-NL" sz="1200" b="1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ale </a:t>
            </a:r>
            <a:r>
              <a:rPr lang="nl-NL" sz="1200" b="1" u="sng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etuses</a:t>
            </a:r>
            <a:endParaRPr lang="en-US" sz="1200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Rectangle 27"/>
          <p:cNvSpPr/>
          <p:nvPr/>
        </p:nvSpPr>
        <p:spPr>
          <a:xfrm>
            <a:off x="-20910" y="6106831"/>
            <a:ext cx="9050380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Bef>
                <a:spcPct val="0"/>
              </a:spcBef>
            </a:pP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ots show the </a:t>
            </a: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near and logistic regression models for total </a:t>
            </a:r>
            <a:r>
              <a:rPr lang="en-US" alt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standardized to gestational age; SD) and </a:t>
            </a:r>
            <a:r>
              <a:rPr lang="en-US" altLang="en-US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rthweight</a:t>
            </a: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standardized to gestational age at birth; SD) or small for gestational age (defined as &lt;10</a:t>
            </a:r>
            <a:r>
              <a:rPr lang="en-US" altLang="en-US" sz="11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ercentile of gestational age specific birth weight) as </a:t>
            </a: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dicted mean with 95 percent confidence interval. Analyses were performed </a:t>
            </a:r>
            <a:r>
              <a:rPr lang="en-US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ter </a:t>
            </a:r>
            <a:r>
              <a: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clusion of </a:t>
            </a:r>
            <a:r>
              <a:rPr lang="en-GB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men with IVF treatment (</a:t>
            </a:r>
            <a:r>
              <a:rPr lang="en-GB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=38), </a:t>
            </a:r>
            <a:r>
              <a:rPr lang="en-GB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win pregnancy (</a:t>
            </a:r>
            <a:r>
              <a:rPr lang="en-GB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=90) and </a:t>
            </a:r>
            <a:r>
              <a:rPr lang="en-GB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adjusted for maternal age, smoking, BMI, parity</a:t>
            </a:r>
            <a:r>
              <a:rPr lang="en-GB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placental weight at birth, </a:t>
            </a:r>
            <a:r>
              <a:rPr lang="en-GB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ducation level, </a:t>
            </a:r>
            <a:r>
              <a:rPr lang="en-GB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hnicity, gestational age at birth and gestational weight gain.</a:t>
            </a:r>
            <a:endParaRPr lang="en-US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291173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83</TotalTime>
  <Words>2166</Words>
  <Application>Microsoft Office PowerPoint</Application>
  <PresentationFormat>On-screen Show (4:3)</PresentationFormat>
  <Paragraphs>377</Paragraphs>
  <Slides>11</Slides>
  <Notes>1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3" baseType="lpstr">
      <vt:lpstr>Office Theme</vt:lpstr>
      <vt:lpstr>Documen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Erasmus M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. Barjaktarovic</dc:creator>
  <cp:lastModifiedBy>M. Barjaktarovic</cp:lastModifiedBy>
  <cp:revision>18</cp:revision>
  <dcterms:created xsi:type="dcterms:W3CDTF">2016-02-05T13:55:21Z</dcterms:created>
  <dcterms:modified xsi:type="dcterms:W3CDTF">2016-09-14T12:30:05Z</dcterms:modified>
</cp:coreProperties>
</file>